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theme/themeOverride1.xml" ContentType="application/vnd.openxmlformats-officedocument.themeOverrid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76" r:id="rId2"/>
    <p:sldId id="285" r:id="rId3"/>
    <p:sldId id="284" r:id="rId4"/>
    <p:sldId id="277" r:id="rId5"/>
    <p:sldId id="256" r:id="rId6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orient="horz" pos="8046" userDrawn="1">
          <p15:clr>
            <a:srgbClr val="A4A3A4"/>
          </p15:clr>
        </p15:guide>
        <p15:guide id="9" orient="horz" pos="6255" userDrawn="1">
          <p15:clr>
            <a:srgbClr val="A4A3A4"/>
          </p15:clr>
        </p15:guide>
        <p15:guide id="11" orient="horz" pos="3488" userDrawn="1">
          <p15:clr>
            <a:srgbClr val="A4A3A4"/>
          </p15:clr>
        </p15:guide>
        <p15:guide id="12" pos="3024">
          <p15:clr>
            <a:srgbClr val="A4A3A4"/>
          </p15:clr>
        </p15:guide>
        <p15:guide id="13" orient="horz" pos="573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75DCB02-9BB8-47FD-8907-85C794F793BA}" styleName="テーマ スタイル 1 - アクセント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554"/>
    <p:restoredTop sz="94663"/>
  </p:normalViewPr>
  <p:slideViewPr>
    <p:cSldViewPr snapToGrid="0" snapToObjects="1" showGuides="1">
      <p:cViewPr varScale="1">
        <p:scale>
          <a:sx n="64" d="100"/>
          <a:sy n="64" d="100"/>
        </p:scale>
        <p:origin x="2360" y="176"/>
      </p:cViewPr>
      <p:guideLst>
        <p:guide orient="horz" pos="8046"/>
        <p:guide orient="horz" pos="6255"/>
        <p:guide orient="horz" pos="3488"/>
        <p:guide pos="3024"/>
        <p:guide orient="horz" pos="573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Hiroko2013:Dropbox:&#23398;&#29983;:Ai%20Hanazaki:2015-Pa&#25913;&#22793;&#20013;:2015%20&#23455;&#39443;:Real-time%20PCR:20151021%20Real-time%20PCR%20&#12414;&#12392;&#12417;%20(Npt2a,%20Npt2c)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23455;&#39443;PKL2015\Real-time%20PCR2015\20151008%20Real-time%20PCR%20&#12414;&#12392;&#12417;%205w%20%20(1aOHase,%2024OHase)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23455;&#39443;PKL2015\Real-time%20PCR2015\20151008%20Real-time%20PCR%20&#12414;&#12392;&#12417;%205w%20%20(1aOHase,%2024OHase)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23455;&#39443;PKL2015\Real-time%20PCR2015\20151021%20Real-time%20PCR%20&#12414;&#12392;&#12417;%20(Npt2a,%20Npt2c)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12414;&#12392;&#12417;PKL\&#12414;&#12392;&#12417;&#12486;&#12441;&#12540;&#12479;\&#34880;&#28082;&#12486;&#12441;&#12540;&#12479;\2016.iCa,%20plasma%20pH&#12414;&#12392;&#12417;%20(5wk,%208wk%20Male)%20new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2019-Hiroko\2019-&#35542;&#25991;\2019-PKL\2019%20PKL%20May\20190603%20blood%20data%20&#12414;&#12392;&#12417;%20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12414;&#12392;&#12417;PKL\&#20195;&#35613;&#12465;&#12540;&#12471;&#12441;\20190722%20&#20195;&#35613;&#12465;&#12540;&#12471;&#12441;Ca&#25490;&#27844;.xls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Owner\Drop%20Box\Dropbox\Ai%20Hanazaki\&#23455;&#39443;PKL\&#12414;&#12392;&#12417;PKL\&#20195;&#35613;&#12465;&#12540;&#12472;\20190722%20&#20195;&#35613;&#12465;&#12540;&#12472;Ca&#25490;&#27844;.xls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Owner\Drop%20Box\Dropbox\Ai%20Hanazaki\&#23455;&#39443;PKL\&#23455;&#39443;PKL2018\FGF23%2020180315&#28204;&#23450;%20&#33457;&#23822;&#25913;&#22793;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2019-Hiroko\2019-&#35542;&#25991;\2019-PKL\2019%20PKL%20May\20190523%20PTH%20PK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23455;&#39443;PKL2019\2019%20W.B.&#29983;&#24460;\20190205&#27891;&#21205;&#20998;W.B%20&#12420;&#12426;&#30452;&#12375;&#12383;version\W.B.&#29983;&#24460;%20&#25968;&#20516;&#21270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Hiroko2013:Dropbox:&#23398;&#29983;:Ai%20Hanazaki:2015-Pa&#25913;&#22793;&#20013;:2015%20&#23455;&#39443;:Real-time%20PCR:20151021%20Real-time%20PCR%20&#12414;&#12392;&#12417;%20(Npt2a,%20Npt2c)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23455;&#39443;PKL2019\2019%20W.B.&#29983;&#24460;\20190205&#27891;&#21205;&#20998;W.B%20&#12420;&#12426;&#30452;&#12375;&#12383;version\W.B.&#29983;&#24460;%20&#25968;&#20516;&#2127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23455;&#39443;PKL2017\2017\20171010-KLKO%20LP&#39164;&#32946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12414;&#12392;&#12417;PKL\&#12414;&#12392;&#12417;&#12486;&#12441;&#12540;&#12479;\&#34880;&#28082;&#12486;&#12441;&#12540;&#12479;\20190612%20LP&#39180;&#39164;&#32946;KLKO&#12510;&#12454;&#12473;&#34880;&#20013;&#12486;&#12441;&#12540;&#12479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23455;&#39443;PKL2019\2019&#33102;Real-time%20PCR\20190721%201aOHase,%2024OHase&#12414;&#12392;&#12417;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35542;&#25991;PKL\&#35542;&#25991;Fig&#29992;&#12486;&#12441;&#12540;&#12479;\2018-20160706%208w%20GAPDH%201aOHase%2024OHase.xls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/C:\Users\Owner\Drop%20Box\Dropbox\Ai%20Hanazaki\Pa%20&#30740;&#31350;\&#12414;&#12392;&#12417;&#12487;&#12540;&#12479;\2016.iCa,%20plasma%20pH&#12414;&#12392;&#12417;%20(5wk,%208wk%20Male)%20new.xlsx" TargetMode="External"/><Relationship Id="rId1" Type="http://schemas.openxmlformats.org/officeDocument/2006/relationships/themeOverride" Target="../theme/themeOverride1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12414;&#12392;&#12417;PKL\&#20195;&#35613;&#12465;&#12540;&#12471;&#12441;\20190722%20&#20195;&#35613;&#12465;&#12540;&#12471;&#12441;Ca&#25490;&#27844;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hirokosegawa2018\Dropbox\&#23398;&#29983;\2019&#23398;&#29983;&#20491;&#20154;\Ai%20Hanazaki\&#23455;&#39443;PKL\&#23455;&#39443;PKL2015\Real-time%20PCR2015\20151021%20Real-time%20PCR%20&#12414;&#12392;&#12417;%20(Npt2a,%20Npt2c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週齢まとめ訂正前 (3)'!$S$71:$T$71</c:f>
                <c:numCache>
                  <c:formatCode>General</c:formatCode>
                  <c:ptCount val="2"/>
                  <c:pt idx="0">
                    <c:v>0.172893976749557</c:v>
                  </c:pt>
                  <c:pt idx="1">
                    <c:v>0.128486499943962</c:v>
                  </c:pt>
                </c:numCache>
              </c:numRef>
            </c:plus>
            <c:minus>
              <c:numRef>
                <c:f>'5週齢まとめ訂正前 (3)'!$S$71:$T$71</c:f>
                <c:numCache>
                  <c:formatCode>General</c:formatCode>
                  <c:ptCount val="2"/>
                  <c:pt idx="0">
                    <c:v>0.172893976749557</c:v>
                  </c:pt>
                  <c:pt idx="1">
                    <c:v>0.128486499943962</c:v>
                  </c:pt>
                </c:numCache>
              </c:numRef>
            </c:minus>
            <c:spPr>
              <a:ln w="25400"/>
            </c:spPr>
          </c:errBars>
          <c:cat>
            <c:strRef>
              <c:f>'5週齢まとめ訂正前 (3)'!$S$56:$T$56</c:f>
              <c:strCache>
                <c:ptCount val="2"/>
                <c:pt idx="0">
                  <c:v>WT</c:v>
                </c:pt>
                <c:pt idx="1">
                  <c:v>KLKO</c:v>
                </c:pt>
              </c:strCache>
            </c:strRef>
          </c:cat>
          <c:val>
            <c:numRef>
              <c:f>'5週齢まとめ訂正前 (3)'!$S$67:$T$67</c:f>
              <c:numCache>
                <c:formatCode>General</c:formatCode>
                <c:ptCount val="2"/>
                <c:pt idx="0">
                  <c:v>1</c:v>
                </c:pt>
                <c:pt idx="1">
                  <c:v>0.89543938451567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E2-F049-9DE0-DC586F2C59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9354624"/>
        <c:axId val="239356160"/>
      </c:barChart>
      <c:catAx>
        <c:axId val="2393546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 b="1" i="0">
                <a:latin typeface="Helvetica" pitchFamily="2" charset="0"/>
              </a:defRPr>
            </a:pPr>
            <a:endParaRPr lang="ja-JP"/>
          </a:p>
        </c:txPr>
        <c:crossAx val="239356160"/>
        <c:crosses val="autoZero"/>
        <c:auto val="1"/>
        <c:lblAlgn val="ctr"/>
        <c:lblOffset val="100"/>
        <c:noMultiLvlLbl val="0"/>
      </c:catAx>
      <c:valAx>
        <c:axId val="2393561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393546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週齢まとめ訂正後'!$U$64:$Z$64</c:f>
                <c:numCache>
                  <c:formatCode>General</c:formatCode>
                  <c:ptCount val="6"/>
                  <c:pt idx="0">
                    <c:v>0.2634447644453623</c:v>
                  </c:pt>
                  <c:pt idx="1">
                    <c:v>9.557878383302594E-2</c:v>
                  </c:pt>
                  <c:pt idx="2">
                    <c:v>0.30257562551757228</c:v>
                  </c:pt>
                  <c:pt idx="3">
                    <c:v>0.13592886653652195</c:v>
                  </c:pt>
                  <c:pt idx="4">
                    <c:v>0.15591459603272106</c:v>
                  </c:pt>
                  <c:pt idx="5">
                    <c:v>0.20322119511184428</c:v>
                  </c:pt>
                </c:numCache>
              </c:numRef>
            </c:plus>
            <c:minus>
              <c:numRef>
                <c:f>'5週齢まとめ訂正後'!$U$64:$Z$64</c:f>
                <c:numCache>
                  <c:formatCode>General</c:formatCode>
                  <c:ptCount val="6"/>
                  <c:pt idx="0">
                    <c:v>0.2634447644453623</c:v>
                  </c:pt>
                  <c:pt idx="1">
                    <c:v>9.557878383302594E-2</c:v>
                  </c:pt>
                  <c:pt idx="2">
                    <c:v>0.30257562551757228</c:v>
                  </c:pt>
                  <c:pt idx="3">
                    <c:v>0.13592886653652195</c:v>
                  </c:pt>
                  <c:pt idx="4">
                    <c:v>0.15591459603272106</c:v>
                  </c:pt>
                  <c:pt idx="5">
                    <c:v>0.20322119511184428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5週齢まとめ訂正後'!$U$53:$Z$53</c:f>
              <c:strCache>
                <c:ptCount val="6"/>
                <c:pt idx="0">
                  <c:v>WT</c:v>
                </c:pt>
                <c:pt idx="1">
                  <c:v>KLKO</c:v>
                </c:pt>
                <c:pt idx="2">
                  <c:v>KL2aDKO</c:v>
                </c:pt>
                <c:pt idx="3">
                  <c:v>Npt2aKO</c:v>
                </c:pt>
                <c:pt idx="4">
                  <c:v>KL2cDKO</c:v>
                </c:pt>
                <c:pt idx="5">
                  <c:v>Npt2cKO</c:v>
                </c:pt>
              </c:strCache>
            </c:strRef>
          </c:cat>
          <c:val>
            <c:numRef>
              <c:f>'5週齢まとめ訂正後'!$U$60:$Z$60</c:f>
              <c:numCache>
                <c:formatCode>General</c:formatCode>
                <c:ptCount val="6"/>
                <c:pt idx="0">
                  <c:v>1</c:v>
                </c:pt>
                <c:pt idx="1">
                  <c:v>0.46948775985671654</c:v>
                </c:pt>
                <c:pt idx="2">
                  <c:v>0.43684756798249824</c:v>
                </c:pt>
                <c:pt idx="3">
                  <c:v>0.66731782606848822</c:v>
                </c:pt>
                <c:pt idx="4">
                  <c:v>0.61789596503572242</c:v>
                </c:pt>
                <c:pt idx="5">
                  <c:v>0.62611339499046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CB-5948-93AE-FC0769148D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142464"/>
        <c:axId val="268144000"/>
      </c:barChart>
      <c:catAx>
        <c:axId val="2681424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8144000"/>
        <c:crosses val="autoZero"/>
        <c:auto val="1"/>
        <c:lblAlgn val="ctr"/>
        <c:lblOffset val="100"/>
        <c:noMultiLvlLbl val="0"/>
      </c:catAx>
      <c:valAx>
        <c:axId val="268144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814246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週齢まとめ訂正後'!$U$30:$Z$30</c:f>
                <c:numCache>
                  <c:formatCode>General</c:formatCode>
                  <c:ptCount val="6"/>
                  <c:pt idx="0">
                    <c:v>0.20553325412739482</c:v>
                  </c:pt>
                  <c:pt idx="1">
                    <c:v>1.8230275293136877</c:v>
                  </c:pt>
                  <c:pt idx="2">
                    <c:v>1.0465158110138659</c:v>
                  </c:pt>
                  <c:pt idx="3">
                    <c:v>0.67555849326700668</c:v>
                  </c:pt>
                  <c:pt idx="4">
                    <c:v>1.9617852978137194</c:v>
                  </c:pt>
                  <c:pt idx="5">
                    <c:v>0.18315165368965564</c:v>
                  </c:pt>
                </c:numCache>
              </c:numRef>
            </c:plus>
            <c:minus>
              <c:numRef>
                <c:f>'5週齢まとめ訂正後'!$U$30:$Z$30</c:f>
                <c:numCache>
                  <c:formatCode>General</c:formatCode>
                  <c:ptCount val="6"/>
                  <c:pt idx="0">
                    <c:v>0.20553325412739482</c:v>
                  </c:pt>
                  <c:pt idx="1">
                    <c:v>1.8230275293136877</c:v>
                  </c:pt>
                  <c:pt idx="2">
                    <c:v>1.0465158110138659</c:v>
                  </c:pt>
                  <c:pt idx="3">
                    <c:v>0.67555849326700668</c:v>
                  </c:pt>
                  <c:pt idx="4">
                    <c:v>1.9617852978137194</c:v>
                  </c:pt>
                  <c:pt idx="5">
                    <c:v>0.18315165368965564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5週齢まとめ訂正後'!$U$19:$Z$19</c:f>
              <c:strCache>
                <c:ptCount val="6"/>
                <c:pt idx="0">
                  <c:v>WT</c:v>
                </c:pt>
                <c:pt idx="1">
                  <c:v>KLKO</c:v>
                </c:pt>
                <c:pt idx="2">
                  <c:v>KL2aDKO</c:v>
                </c:pt>
                <c:pt idx="3">
                  <c:v>Npt2aKO</c:v>
                </c:pt>
                <c:pt idx="4">
                  <c:v>KL2cDKO</c:v>
                </c:pt>
                <c:pt idx="5">
                  <c:v>Npt2cKO</c:v>
                </c:pt>
              </c:strCache>
            </c:strRef>
          </c:cat>
          <c:val>
            <c:numRef>
              <c:f>'5週齢まとめ訂正後'!$U$26:$Z$26</c:f>
              <c:numCache>
                <c:formatCode>General</c:formatCode>
                <c:ptCount val="6"/>
                <c:pt idx="0">
                  <c:v>1</c:v>
                </c:pt>
                <c:pt idx="1">
                  <c:v>5.85403782016507</c:v>
                </c:pt>
                <c:pt idx="2">
                  <c:v>5.343187214797144</c:v>
                </c:pt>
                <c:pt idx="3">
                  <c:v>2.8999213010597296</c:v>
                </c:pt>
                <c:pt idx="4">
                  <c:v>6.7324320369826633</c:v>
                </c:pt>
                <c:pt idx="5">
                  <c:v>0.982789846377654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46-9F44-A158-7B4ABF371D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164480"/>
        <c:axId val="267781248"/>
      </c:barChart>
      <c:catAx>
        <c:axId val="268164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781248"/>
        <c:crosses val="autoZero"/>
        <c:auto val="1"/>
        <c:lblAlgn val="ctr"/>
        <c:lblOffset val="100"/>
        <c:noMultiLvlLbl val="0"/>
      </c:catAx>
      <c:valAx>
        <c:axId val="267781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81644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週齢まとめ訂正後'!$S$30:$T$30</c:f>
                <c:numCache>
                  <c:formatCode>General</c:formatCode>
                  <c:ptCount val="2"/>
                  <c:pt idx="0">
                    <c:v>9.1546533824942544E-2</c:v>
                  </c:pt>
                  <c:pt idx="1">
                    <c:v>7.29111401038533E-2</c:v>
                  </c:pt>
                </c:numCache>
              </c:numRef>
            </c:plus>
            <c:minus>
              <c:numRef>
                <c:f>'5週齢まとめ訂正後'!$S$30:$T$30</c:f>
                <c:numCache>
                  <c:formatCode>General</c:formatCode>
                  <c:ptCount val="2"/>
                  <c:pt idx="0">
                    <c:v>9.1546533824942544E-2</c:v>
                  </c:pt>
                  <c:pt idx="1">
                    <c:v>7.29111401038533E-2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5週齢まとめ訂正後'!$S$19:$T$19</c:f>
              <c:strCache>
                <c:ptCount val="2"/>
                <c:pt idx="0">
                  <c:v>WT</c:v>
                </c:pt>
                <c:pt idx="1">
                  <c:v>KLKO</c:v>
                </c:pt>
              </c:strCache>
            </c:strRef>
          </c:cat>
          <c:val>
            <c:numRef>
              <c:f>'5週齢まとめ訂正後'!$S$26:$T$26</c:f>
              <c:numCache>
                <c:formatCode>General</c:formatCode>
                <c:ptCount val="2"/>
                <c:pt idx="0">
                  <c:v>1.0000000000000002</c:v>
                </c:pt>
                <c:pt idx="1">
                  <c:v>0.58011581689477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67-5049-8E0E-DD109556FF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7805824"/>
        <c:axId val="267807360"/>
      </c:barChart>
      <c:catAx>
        <c:axId val="2678058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807360"/>
        <c:crosses val="autoZero"/>
        <c:auto val="1"/>
        <c:lblAlgn val="ctr"/>
        <c:lblOffset val="100"/>
        <c:noMultiLvlLbl val="0"/>
      </c:catAx>
      <c:valAx>
        <c:axId val="2678073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8058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E2D-0D43-88DD-4DD6802BA7C4}"/>
              </c:ext>
            </c:extLst>
          </c:dPt>
          <c:errBars>
            <c:errBarType val="both"/>
            <c:errValType val="cust"/>
            <c:noEndCap val="0"/>
            <c:plus>
              <c:numRef>
                <c:f>'5wk Male (2)'!$N$30:$O$30</c:f>
                <c:numCache>
                  <c:formatCode>General</c:formatCode>
                  <c:ptCount val="2"/>
                  <c:pt idx="0">
                    <c:v>1.8035872122811401E-2</c:v>
                  </c:pt>
                  <c:pt idx="1">
                    <c:v>1.564560352524438E-2</c:v>
                  </c:pt>
                </c:numCache>
              </c:numRef>
            </c:plus>
            <c:minus>
              <c:numRef>
                <c:f>'5wk Male (2)'!$N$30:$O$30</c:f>
                <c:numCache>
                  <c:formatCode>General</c:formatCode>
                  <c:ptCount val="2"/>
                  <c:pt idx="0">
                    <c:v>1.8035872122811401E-2</c:v>
                  </c:pt>
                  <c:pt idx="1">
                    <c:v>1.564560352524438E-2</c:v>
                  </c:pt>
                </c:numCache>
              </c:numRef>
            </c:minus>
            <c:spPr>
              <a:ln w="25400"/>
            </c:spPr>
          </c:errBars>
          <c:cat>
            <c:strRef>
              <c:f>'5wk Male (2)'!$N$28:$O$28</c:f>
              <c:strCache>
                <c:ptCount val="2"/>
                <c:pt idx="0">
                  <c:v>WT</c:v>
                </c:pt>
                <c:pt idx="1">
                  <c:v>KLKO</c:v>
                </c:pt>
              </c:strCache>
            </c:strRef>
          </c:cat>
          <c:val>
            <c:numRef>
              <c:f>'5wk Male (2)'!$N$29:$O$29</c:f>
              <c:numCache>
                <c:formatCode>General</c:formatCode>
                <c:ptCount val="2"/>
                <c:pt idx="0">
                  <c:v>1.263833312241847</c:v>
                </c:pt>
                <c:pt idx="1">
                  <c:v>1.2578497083379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E2D-0D43-88DD-4DD6802BA7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7934720"/>
        <c:axId val="267944704"/>
      </c:barChart>
      <c:catAx>
        <c:axId val="2679347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944704"/>
        <c:crosses val="autoZero"/>
        <c:auto val="1"/>
        <c:lblAlgn val="ctr"/>
        <c:lblOffset val="100"/>
        <c:noMultiLvlLbl val="0"/>
      </c:catAx>
      <c:valAx>
        <c:axId val="26794470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93472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wk Male (2)'!$N$30:$S$30</c:f>
                <c:numCache>
                  <c:formatCode>General</c:formatCode>
                  <c:ptCount val="6"/>
                  <c:pt idx="0">
                    <c:v>1.8035872122811401E-2</c:v>
                  </c:pt>
                  <c:pt idx="1">
                    <c:v>1.564560352524438E-2</c:v>
                  </c:pt>
                  <c:pt idx="2">
                    <c:v>2.9623299715417006E-2</c:v>
                  </c:pt>
                  <c:pt idx="3">
                    <c:v>2.9623299715417006E-2</c:v>
                  </c:pt>
                  <c:pt idx="4">
                    <c:v>2.6489162323069138E-2</c:v>
                  </c:pt>
                  <c:pt idx="5">
                    <c:v>1.3893113386771273E-2</c:v>
                  </c:pt>
                </c:numCache>
              </c:numRef>
            </c:plus>
            <c:minus>
              <c:numRef>
                <c:f>'5wk Male (2)'!$N$30:$S$30</c:f>
                <c:numCache>
                  <c:formatCode>General</c:formatCode>
                  <c:ptCount val="6"/>
                  <c:pt idx="0">
                    <c:v>1.8035872122811401E-2</c:v>
                  </c:pt>
                  <c:pt idx="1">
                    <c:v>1.564560352524438E-2</c:v>
                  </c:pt>
                  <c:pt idx="2">
                    <c:v>2.9623299715417006E-2</c:v>
                  </c:pt>
                  <c:pt idx="3">
                    <c:v>2.9623299715417006E-2</c:v>
                  </c:pt>
                  <c:pt idx="4">
                    <c:v>2.6489162323069138E-2</c:v>
                  </c:pt>
                  <c:pt idx="5">
                    <c:v>1.3893113386771273E-2</c:v>
                  </c:pt>
                </c:numCache>
              </c:numRef>
            </c:minus>
            <c:spPr>
              <a:ln w="25400"/>
            </c:spPr>
          </c:errBars>
          <c:cat>
            <c:strRef>
              <c:f>'5wk Male (2)'!$N$28:$S$28</c:f>
              <c:strCache>
                <c:ptCount val="6"/>
                <c:pt idx="0">
                  <c:v>WT</c:v>
                </c:pt>
                <c:pt idx="1">
                  <c:v>KLKO</c:v>
                </c:pt>
                <c:pt idx="2">
                  <c:v>KL2aDKO</c:v>
                </c:pt>
                <c:pt idx="3">
                  <c:v>Npt2aKO</c:v>
                </c:pt>
                <c:pt idx="4">
                  <c:v>KL2cDKO</c:v>
                </c:pt>
                <c:pt idx="5">
                  <c:v>Npt2cKO</c:v>
                </c:pt>
              </c:strCache>
            </c:strRef>
          </c:cat>
          <c:val>
            <c:numRef>
              <c:f>'5wk Male (2)'!$N$29:$S$29</c:f>
              <c:numCache>
                <c:formatCode>General</c:formatCode>
                <c:ptCount val="6"/>
                <c:pt idx="0">
                  <c:v>1.263833312241847</c:v>
                </c:pt>
                <c:pt idx="1">
                  <c:v>1.2578497083379463</c:v>
                </c:pt>
                <c:pt idx="2">
                  <c:v>1.5696782014383854</c:v>
                </c:pt>
                <c:pt idx="3">
                  <c:v>1.4945514427227993</c:v>
                </c:pt>
                <c:pt idx="4">
                  <c:v>1.3855040587820331</c:v>
                </c:pt>
                <c:pt idx="5">
                  <c:v>1.27013262344464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E3-3E44-923A-DB920BAEEC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7961088"/>
        <c:axId val="267962624"/>
      </c:barChart>
      <c:catAx>
        <c:axId val="267961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962624"/>
        <c:crosses val="autoZero"/>
        <c:auto val="1"/>
        <c:lblAlgn val="ctr"/>
        <c:lblOffset val="100"/>
        <c:noMultiLvlLbl val="0"/>
      </c:catAx>
      <c:valAx>
        <c:axId val="267962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9610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a代謝ケージ5wks,8wksまとめ 2倍した値(3)'!$S$56:$T$56</c:f>
                <c:numCache>
                  <c:formatCode>General</c:formatCode>
                  <c:ptCount val="2"/>
                  <c:pt idx="0">
                    <c:v>2.4676583291565222E-2</c:v>
                  </c:pt>
                  <c:pt idx="1">
                    <c:v>2.9370474320299957E-2</c:v>
                  </c:pt>
                </c:numCache>
              </c:numRef>
            </c:plus>
            <c:minus>
              <c:numRef>
                <c:f>'Ca代謝ケージ5wks,8wksまとめ 2倍した値(3)'!$S$56:$T$56</c:f>
                <c:numCache>
                  <c:formatCode>General</c:formatCode>
                  <c:ptCount val="2"/>
                  <c:pt idx="0">
                    <c:v>2.4676583291565222E-2</c:v>
                  </c:pt>
                  <c:pt idx="1">
                    <c:v>2.9370474320299957E-2</c:v>
                  </c:pt>
                </c:numCache>
              </c:numRef>
            </c:minus>
          </c:errBars>
          <c:cat>
            <c:strRef>
              <c:f>'Ca代謝ケージ5wks,8wksまとめ 2倍した値(3)'!$S$41:$T$41</c:f>
              <c:strCache>
                <c:ptCount val="2"/>
                <c:pt idx="0">
                  <c:v>WT</c:v>
                </c:pt>
                <c:pt idx="1">
                  <c:v>KLKO</c:v>
                </c:pt>
              </c:strCache>
            </c:strRef>
          </c:cat>
          <c:val>
            <c:numRef>
              <c:f>'Ca代謝ケージ5wks,8wksまとめ 2倍した値(3)'!$S$52:$T$52</c:f>
              <c:numCache>
                <c:formatCode>General</c:formatCode>
                <c:ptCount val="2"/>
                <c:pt idx="0">
                  <c:v>0.16037480000000001</c:v>
                </c:pt>
                <c:pt idx="1">
                  <c:v>0.297100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D1-9E47-A676-16631A54B9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007680"/>
        <c:axId val="268013568"/>
      </c:barChart>
      <c:catAx>
        <c:axId val="268007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Helvetica" pitchFamily="2" charset="0"/>
                <a:ea typeface="ＭＳ Ｐゴシック"/>
                <a:cs typeface="ＭＳ Ｐゴシック"/>
              </a:defRPr>
            </a:pPr>
            <a:endParaRPr lang="ja-JP"/>
          </a:p>
        </c:txPr>
        <c:crossAx val="268013568"/>
        <c:crosses val="autoZero"/>
        <c:auto val="1"/>
        <c:lblAlgn val="ctr"/>
        <c:lblOffset val="100"/>
        <c:noMultiLvlLbl val="0"/>
      </c:catAx>
      <c:valAx>
        <c:axId val="268013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Helvetica" pitchFamily="2" charset="0"/>
                <a:ea typeface="ＭＳ Ｐゴシック"/>
                <a:cs typeface="ＭＳ Ｐゴシック"/>
              </a:defRPr>
            </a:pPr>
            <a:endParaRPr lang="ja-JP"/>
          </a:p>
        </c:txPr>
        <c:crossAx val="2680076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a代謝ケージ5wks,8wksまとめ 2倍した値(3)'!$S$56:$X$56</c:f>
                <c:numCache>
                  <c:formatCode>General</c:formatCode>
                  <c:ptCount val="6"/>
                  <c:pt idx="0">
                    <c:v>2.4676583291565222E-2</c:v>
                  </c:pt>
                  <c:pt idx="1">
                    <c:v>2.9370474320299957E-2</c:v>
                  </c:pt>
                  <c:pt idx="2">
                    <c:v>5.833360000000009E-2</c:v>
                  </c:pt>
                  <c:pt idx="3">
                    <c:v>0.27764480000000002</c:v>
                  </c:pt>
                  <c:pt idx="4">
                    <c:v>0.13902983456061185</c:v>
                  </c:pt>
                  <c:pt idx="5">
                    <c:v>6.1871154573436005E-2</c:v>
                  </c:pt>
                </c:numCache>
              </c:numRef>
            </c:plus>
            <c:minus>
              <c:numRef>
                <c:f>'Ca代謝ケージ5wks,8wksまとめ 2倍した値(3)'!$S$56:$X$56</c:f>
                <c:numCache>
                  <c:formatCode>General</c:formatCode>
                  <c:ptCount val="6"/>
                  <c:pt idx="0">
                    <c:v>2.4676583291565222E-2</c:v>
                  </c:pt>
                  <c:pt idx="1">
                    <c:v>2.9370474320299957E-2</c:v>
                  </c:pt>
                  <c:pt idx="2">
                    <c:v>5.833360000000009E-2</c:v>
                  </c:pt>
                  <c:pt idx="3">
                    <c:v>0.27764480000000002</c:v>
                  </c:pt>
                  <c:pt idx="4">
                    <c:v>0.13902983456061185</c:v>
                  </c:pt>
                  <c:pt idx="5">
                    <c:v>6.1871154573436005E-2</c:v>
                  </c:pt>
                </c:numCache>
              </c:numRef>
            </c:minus>
            <c:spPr>
              <a:ln w="25400"/>
            </c:spPr>
          </c:errBars>
          <c:cat>
            <c:strRef>
              <c:f>'Ca代謝ケージ5wks,8wksまとめ 2倍した値(3)'!$S$41:$X$41</c:f>
              <c:strCache>
                <c:ptCount val="6"/>
                <c:pt idx="0">
                  <c:v>WT</c:v>
                </c:pt>
                <c:pt idx="1">
                  <c:v>KLKO</c:v>
                </c:pt>
                <c:pt idx="2">
                  <c:v>KL2aDKO</c:v>
                </c:pt>
                <c:pt idx="3">
                  <c:v>Npt2aKO</c:v>
                </c:pt>
                <c:pt idx="4">
                  <c:v>KL2cDKO</c:v>
                </c:pt>
                <c:pt idx="5">
                  <c:v>Npt2cKO</c:v>
                </c:pt>
              </c:strCache>
            </c:strRef>
          </c:cat>
          <c:val>
            <c:numRef>
              <c:f>'Ca代謝ケージ5wks,8wksまとめ 2倍した値(3)'!$S$52:$X$52</c:f>
              <c:numCache>
                <c:formatCode>General</c:formatCode>
                <c:ptCount val="6"/>
                <c:pt idx="0">
                  <c:v>0.16037480000000001</c:v>
                </c:pt>
                <c:pt idx="1">
                  <c:v>0.29710048</c:v>
                </c:pt>
                <c:pt idx="2">
                  <c:v>1.4603626000000001</c:v>
                </c:pt>
                <c:pt idx="3">
                  <c:v>0.35277769999999997</c:v>
                </c:pt>
                <c:pt idx="4">
                  <c:v>0.48615273333333336</c:v>
                </c:pt>
                <c:pt idx="5">
                  <c:v>0.2793724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33-FC4A-9014-FB4D22A3FC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9103104"/>
        <c:axId val="269104640"/>
      </c:barChart>
      <c:catAx>
        <c:axId val="269103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-270000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Helvetica" panose="020B0604020202020204" pitchFamily="34" charset="0"/>
                <a:ea typeface="ＭＳ Ｐゴシック"/>
                <a:cs typeface="Helvetica" panose="020B0604020202020204" pitchFamily="34" charset="0"/>
              </a:defRPr>
            </a:pPr>
            <a:endParaRPr lang="ja-JP"/>
          </a:p>
        </c:txPr>
        <c:crossAx val="269104640"/>
        <c:crosses val="autoZero"/>
        <c:auto val="1"/>
        <c:lblAlgn val="ctr"/>
        <c:lblOffset val="100"/>
        <c:noMultiLvlLbl val="0"/>
      </c:catAx>
      <c:valAx>
        <c:axId val="269104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Helvetica" panose="020B0604020202020204" pitchFamily="34" charset="0"/>
                <a:ea typeface="ＭＳ Ｐゴシック"/>
                <a:cs typeface="Helvetica" panose="020B0604020202020204" pitchFamily="34" charset="0"/>
              </a:defRPr>
            </a:pPr>
            <a:endParaRPr lang="ja-JP"/>
          </a:p>
        </c:txPr>
        <c:crossAx val="2691031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WT 15-28days'!$J$10:$M$10</c:f>
                <c:numCache>
                  <c:formatCode>General</c:formatCode>
                  <c:ptCount val="4"/>
                  <c:pt idx="0">
                    <c:v>44.097303233241384</c:v>
                  </c:pt>
                  <c:pt idx="1">
                    <c:v>4.0649774087113144</c:v>
                  </c:pt>
                  <c:pt idx="2">
                    <c:v>12.290303874735292</c:v>
                  </c:pt>
                  <c:pt idx="3">
                    <c:v>7.2963845232492472</c:v>
                  </c:pt>
                </c:numCache>
              </c:numRef>
            </c:plus>
            <c:minus>
              <c:numRef>
                <c:f>'WT 15-28days'!$J$10:$M$10</c:f>
                <c:numCache>
                  <c:formatCode>General</c:formatCode>
                  <c:ptCount val="4"/>
                  <c:pt idx="0">
                    <c:v>44.097303233241384</c:v>
                  </c:pt>
                  <c:pt idx="1">
                    <c:v>4.0649774087113144</c:v>
                  </c:pt>
                  <c:pt idx="2">
                    <c:v>12.290303874735292</c:v>
                  </c:pt>
                  <c:pt idx="3">
                    <c:v>7.2963845232492472</c:v>
                  </c:pt>
                </c:numCache>
              </c:numRef>
            </c:minus>
            <c:spPr>
              <a:ln w="25400"/>
            </c:spPr>
          </c:errBars>
          <c:cat>
            <c:strRef>
              <c:f>'WT 15-28days'!$J$2:$M$2</c:f>
              <c:strCache>
                <c:ptCount val="4"/>
                <c:pt idx="0">
                  <c:v>15D</c:v>
                </c:pt>
                <c:pt idx="1">
                  <c:v>21D</c:v>
                </c:pt>
                <c:pt idx="2">
                  <c:v>28D</c:v>
                </c:pt>
                <c:pt idx="3">
                  <c:v>60D</c:v>
                </c:pt>
              </c:strCache>
            </c:strRef>
          </c:cat>
          <c:val>
            <c:numRef>
              <c:f>'WT 15-28days'!$J$6:$M$6</c:f>
              <c:numCache>
                <c:formatCode>General</c:formatCode>
                <c:ptCount val="4"/>
                <c:pt idx="0">
                  <c:v>192.07266666666669</c:v>
                </c:pt>
                <c:pt idx="1">
                  <c:v>86.76700000000001</c:v>
                </c:pt>
                <c:pt idx="2">
                  <c:v>41.25</c:v>
                </c:pt>
                <c:pt idx="3">
                  <c:v>117.14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0A-5045-9914-BCF09667A0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2339200"/>
        <c:axId val="132340736"/>
      </c:barChart>
      <c:catAx>
        <c:axId val="1323392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 b="1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132340736"/>
        <c:crosses val="autoZero"/>
        <c:auto val="1"/>
        <c:lblAlgn val="ctr"/>
        <c:lblOffset val="100"/>
        <c:noMultiLvlLbl val="0"/>
      </c:catAx>
      <c:valAx>
        <c:axId val="1323407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 b="1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1323392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679887946227978"/>
          <c:y val="6.1921508172132038E-2"/>
          <c:w val="0.77847481669430407"/>
          <c:h val="0.79926172896197933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まとめ!$O$44:$R$44</c:f>
                <c:numCache>
                  <c:formatCode>General</c:formatCode>
                  <c:ptCount val="4"/>
                  <c:pt idx="0">
                    <c:v>20.626304672539963</c:v>
                  </c:pt>
                  <c:pt idx="1">
                    <c:v>1.7800007802744873</c:v>
                  </c:pt>
                  <c:pt idx="2">
                    <c:v>2.5115474055590479</c:v>
                  </c:pt>
                  <c:pt idx="3">
                    <c:v>3.7371177908538096</c:v>
                  </c:pt>
                </c:numCache>
              </c:numRef>
            </c:plus>
            <c:minus>
              <c:numRef>
                <c:f>まとめ!$O$44:$R$44</c:f>
                <c:numCache>
                  <c:formatCode>General</c:formatCode>
                  <c:ptCount val="4"/>
                  <c:pt idx="0">
                    <c:v>20.626304672539963</c:v>
                  </c:pt>
                  <c:pt idx="1">
                    <c:v>1.7800007802744873</c:v>
                  </c:pt>
                  <c:pt idx="2">
                    <c:v>2.5115474055590479</c:v>
                  </c:pt>
                  <c:pt idx="3">
                    <c:v>3.7371177908538096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まとめ!$O$34:$R$34</c:f>
              <c:strCache>
                <c:ptCount val="4"/>
                <c:pt idx="0">
                  <c:v>15D</c:v>
                </c:pt>
                <c:pt idx="1">
                  <c:v>21D</c:v>
                </c:pt>
                <c:pt idx="2">
                  <c:v>28D</c:v>
                </c:pt>
                <c:pt idx="3">
                  <c:v>60D</c:v>
                </c:pt>
              </c:strCache>
            </c:strRef>
          </c:cat>
          <c:val>
            <c:numRef>
              <c:f>まとめ!$O$40:$R$40</c:f>
              <c:numCache>
                <c:formatCode>0.0</c:formatCode>
                <c:ptCount val="4"/>
                <c:pt idx="0">
                  <c:v>136.58333333333334</c:v>
                </c:pt>
                <c:pt idx="1">
                  <c:v>59.875</c:v>
                </c:pt>
                <c:pt idx="2">
                  <c:v>62.166666666666671</c:v>
                </c:pt>
                <c:pt idx="3">
                  <c:v>65.63888888888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45-B040-920B-A266E43421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251904"/>
        <c:axId val="268253440"/>
      </c:barChart>
      <c:catAx>
        <c:axId val="268251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 b="1" i="0">
                <a:latin typeface="Helvetica" pitchFamily="2" charset="0"/>
              </a:defRPr>
            </a:pPr>
            <a:endParaRPr lang="ja-JP"/>
          </a:p>
        </c:txPr>
        <c:crossAx val="268253440"/>
        <c:crosses val="autoZero"/>
        <c:auto val="1"/>
        <c:lblAlgn val="ctr"/>
        <c:lblOffset val="100"/>
        <c:noMultiLvlLbl val="0"/>
      </c:catAx>
      <c:valAx>
        <c:axId val="268253440"/>
        <c:scaling>
          <c:orientation val="minMax"/>
        </c:scaling>
        <c:delete val="0"/>
        <c:axPos val="l"/>
        <c:numFmt formatCode="0_ 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 b="1" i="0">
                <a:latin typeface="Helvetica" pitchFamily="2" charset="0"/>
              </a:defRPr>
            </a:pPr>
            <a:endParaRPr lang="ja-JP"/>
          </a:p>
        </c:txPr>
        <c:crossAx val="2682519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BBM!$J$25:$M$25</c:f>
                <c:numCache>
                  <c:formatCode>General</c:formatCode>
                  <c:ptCount val="4"/>
                  <c:pt idx="0">
                    <c:v>9.0753620968856627E-3</c:v>
                  </c:pt>
                  <c:pt idx="1">
                    <c:v>2.661659694868997E-2</c:v>
                  </c:pt>
                  <c:pt idx="2">
                    <c:v>5.1258447165054115E-2</c:v>
                  </c:pt>
                  <c:pt idx="3">
                    <c:v>0.14213397080986684</c:v>
                  </c:pt>
                </c:numCache>
              </c:numRef>
            </c:plus>
            <c:minus>
              <c:numRef>
                <c:f>BBM!$J$25:$M$25</c:f>
                <c:numCache>
                  <c:formatCode>General</c:formatCode>
                  <c:ptCount val="4"/>
                  <c:pt idx="0">
                    <c:v>9.0753620968856627E-3</c:v>
                  </c:pt>
                  <c:pt idx="1">
                    <c:v>2.661659694868997E-2</c:v>
                  </c:pt>
                  <c:pt idx="2">
                    <c:v>5.1258447165054115E-2</c:v>
                  </c:pt>
                  <c:pt idx="3">
                    <c:v>0.14213397080986684</c:v>
                  </c:pt>
                </c:numCache>
              </c:numRef>
            </c:minus>
            <c:spPr>
              <a:ln w="25400"/>
            </c:spPr>
          </c:errBars>
          <c:cat>
            <c:strRef>
              <c:f>BBM!$J$17:$M$17</c:f>
              <c:strCache>
                <c:ptCount val="4"/>
                <c:pt idx="0">
                  <c:v>15D</c:v>
                </c:pt>
                <c:pt idx="1">
                  <c:v>21D</c:v>
                </c:pt>
                <c:pt idx="2">
                  <c:v>28D</c:v>
                </c:pt>
                <c:pt idx="3">
                  <c:v>60D</c:v>
                </c:pt>
              </c:strCache>
            </c:strRef>
          </c:cat>
          <c:val>
            <c:numRef>
              <c:f>BBM!$J$21:$M$21</c:f>
              <c:numCache>
                <c:formatCode>General</c:formatCode>
                <c:ptCount val="4"/>
                <c:pt idx="0">
                  <c:v>0.10406927060827477</c:v>
                </c:pt>
                <c:pt idx="1">
                  <c:v>0.18552190575304431</c:v>
                </c:pt>
                <c:pt idx="2">
                  <c:v>0.68655802608287753</c:v>
                </c:pt>
                <c:pt idx="3">
                  <c:v>0.559995493806236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61-3745-9CA1-43886BFB0A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314880"/>
        <c:axId val="268320768"/>
      </c:barChart>
      <c:catAx>
        <c:axId val="268314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8320768"/>
        <c:crosses val="autoZero"/>
        <c:auto val="1"/>
        <c:lblAlgn val="ctr"/>
        <c:lblOffset val="100"/>
        <c:noMultiLvlLbl val="0"/>
      </c:catAx>
      <c:valAx>
        <c:axId val="268320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83148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週齢まとめ訂正前 (3)'!$W$71:$X$71</c:f>
                <c:numCache>
                  <c:formatCode>General</c:formatCode>
                  <c:ptCount val="2"/>
                  <c:pt idx="0">
                    <c:v>0.23116717500105299</c:v>
                  </c:pt>
                  <c:pt idx="1">
                    <c:v>8.7694019366573006E-2</c:v>
                  </c:pt>
                </c:numCache>
              </c:numRef>
            </c:plus>
            <c:minus>
              <c:numRef>
                <c:f>'5週齢まとめ訂正前 (3)'!$W$71:$X$71</c:f>
                <c:numCache>
                  <c:formatCode>General</c:formatCode>
                  <c:ptCount val="2"/>
                  <c:pt idx="0">
                    <c:v>0.23116717500105299</c:v>
                  </c:pt>
                  <c:pt idx="1">
                    <c:v>8.7694019366573006E-2</c:v>
                  </c:pt>
                </c:numCache>
              </c:numRef>
            </c:minus>
            <c:spPr>
              <a:ln w="25400"/>
            </c:spPr>
          </c:errBars>
          <c:cat>
            <c:strRef>
              <c:f>'5週齢まとめ訂正前 (3)'!$W$56:$X$56</c:f>
              <c:strCache>
                <c:ptCount val="2"/>
                <c:pt idx="0">
                  <c:v>WT</c:v>
                </c:pt>
                <c:pt idx="1">
                  <c:v>KLKO</c:v>
                </c:pt>
              </c:strCache>
            </c:strRef>
          </c:cat>
          <c:val>
            <c:numRef>
              <c:f>'5週齢まとめ訂正前 (3)'!$W$67:$X$67</c:f>
              <c:numCache>
                <c:formatCode>General</c:formatCode>
                <c:ptCount val="2"/>
                <c:pt idx="0">
                  <c:v>1</c:v>
                </c:pt>
                <c:pt idx="1">
                  <c:v>0.685237425322661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5A-5C4C-A8C1-9B7E6B5565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9380736"/>
        <c:axId val="235405312"/>
      </c:barChart>
      <c:catAx>
        <c:axId val="23938073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 b="1" i="0">
                <a:latin typeface="Helvetica" pitchFamily="2" charset="0"/>
              </a:defRPr>
            </a:pPr>
            <a:endParaRPr lang="ja-JP"/>
          </a:p>
        </c:txPr>
        <c:crossAx val="235405312"/>
        <c:crosses val="autoZero"/>
        <c:auto val="1"/>
        <c:lblAlgn val="ctr"/>
        <c:lblOffset val="100"/>
        <c:noMultiLvlLbl val="0"/>
      </c:catAx>
      <c:valAx>
        <c:axId val="235405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3938073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BBM!$C$25:$F$25</c:f>
                <c:numCache>
                  <c:formatCode>General</c:formatCode>
                  <c:ptCount val="4"/>
                  <c:pt idx="0">
                    <c:v>1.7640406607596346E-2</c:v>
                  </c:pt>
                  <c:pt idx="1">
                    <c:v>3.4166432141997084E-2</c:v>
                  </c:pt>
                  <c:pt idx="2">
                    <c:v>8.2792497431209075E-2</c:v>
                  </c:pt>
                  <c:pt idx="3">
                    <c:v>3.5707126893969592E-2</c:v>
                  </c:pt>
                </c:numCache>
              </c:numRef>
            </c:plus>
            <c:minus>
              <c:numRef>
                <c:f>BBM!$C$25:$F$25</c:f>
                <c:numCache>
                  <c:formatCode>General</c:formatCode>
                  <c:ptCount val="4"/>
                  <c:pt idx="0">
                    <c:v>1.7640406607596346E-2</c:v>
                  </c:pt>
                  <c:pt idx="1">
                    <c:v>3.4166432141997084E-2</c:v>
                  </c:pt>
                  <c:pt idx="2">
                    <c:v>8.2792497431209075E-2</c:v>
                  </c:pt>
                  <c:pt idx="3">
                    <c:v>3.5707126893969592E-2</c:v>
                  </c:pt>
                </c:numCache>
              </c:numRef>
            </c:minus>
            <c:spPr>
              <a:ln w="25400"/>
            </c:spPr>
          </c:errBars>
          <c:cat>
            <c:strRef>
              <c:f>BBM!$C$17:$F$17</c:f>
              <c:strCache>
                <c:ptCount val="4"/>
                <c:pt idx="0">
                  <c:v>15D</c:v>
                </c:pt>
                <c:pt idx="1">
                  <c:v>21D</c:v>
                </c:pt>
                <c:pt idx="2">
                  <c:v>28D</c:v>
                </c:pt>
                <c:pt idx="3">
                  <c:v>60D</c:v>
                </c:pt>
              </c:strCache>
            </c:strRef>
          </c:cat>
          <c:val>
            <c:numRef>
              <c:f>BBM!$C$21:$F$21</c:f>
              <c:numCache>
                <c:formatCode>General</c:formatCode>
                <c:ptCount val="4"/>
                <c:pt idx="0">
                  <c:v>7.0283232267036741E-2</c:v>
                </c:pt>
                <c:pt idx="1">
                  <c:v>0.26370250563260428</c:v>
                </c:pt>
                <c:pt idx="2">
                  <c:v>0.97402100214854848</c:v>
                </c:pt>
                <c:pt idx="3">
                  <c:v>1.25889790918407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A70-604D-A77E-F2CDE3793D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382208"/>
        <c:axId val="268383744"/>
      </c:barChart>
      <c:catAx>
        <c:axId val="2683822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Helvetica" pitchFamily="2" charset="0"/>
              </a:defRPr>
            </a:pPr>
            <a:endParaRPr lang="ja-JP"/>
          </a:p>
        </c:txPr>
        <c:crossAx val="268383744"/>
        <c:crosses val="autoZero"/>
        <c:auto val="1"/>
        <c:lblAlgn val="ctr"/>
        <c:lblOffset val="100"/>
        <c:noMultiLvlLbl val="0"/>
      </c:catAx>
      <c:valAx>
        <c:axId val="268383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Helvetica" pitchFamily="2" charset="0"/>
              </a:defRPr>
            </a:pPr>
            <a:endParaRPr lang="ja-JP"/>
          </a:p>
        </c:txPr>
        <c:crossAx val="2683822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9288205306865385E-2"/>
          <c:y val="6.3798373392653179E-2"/>
          <c:w val="0.69253606521244526"/>
          <c:h val="0.81073210117682193"/>
        </c:manualLayout>
      </c:layout>
      <c:scatterChart>
        <c:scatterStyle val="lineMarker"/>
        <c:varyColors val="0"/>
        <c:ser>
          <c:idx val="0"/>
          <c:order val="0"/>
          <c:tx>
            <c:strRef>
              <c:f>'B.W. 等 (2)'!$B$59</c:f>
              <c:strCache>
                <c:ptCount val="1"/>
                <c:pt idx="0">
                  <c:v>WT</c:v>
                </c:pt>
              </c:strCache>
            </c:strRef>
          </c:tx>
          <c:spPr>
            <a:ln w="25400"/>
          </c:spPr>
          <c:errBars>
            <c:errDir val="y"/>
            <c:errBarType val="both"/>
            <c:errValType val="cust"/>
            <c:noEndCap val="0"/>
            <c:plus>
              <c:numRef>
                <c:f>'B.W. 等 (2)'!$C$64:$U$64</c:f>
                <c:numCache>
                  <c:formatCode>General</c:formatCode>
                  <c:ptCount val="19"/>
                  <c:pt idx="0">
                    <c:v>0.32499999999999923</c:v>
                  </c:pt>
                  <c:pt idx="1">
                    <c:v>0.41999999999999987</c:v>
                  </c:pt>
                  <c:pt idx="2">
                    <c:v>0.43000000000000144</c:v>
                  </c:pt>
                  <c:pt idx="3">
                    <c:v>0.49000000000000105</c:v>
                  </c:pt>
                  <c:pt idx="4">
                    <c:v>0.72499999999999865</c:v>
                  </c:pt>
                  <c:pt idx="5">
                    <c:v>0.48500000000000032</c:v>
                  </c:pt>
                  <c:pt idx="6">
                    <c:v>0.43500000000000044</c:v>
                  </c:pt>
                  <c:pt idx="7">
                    <c:v>0.96000000000000074</c:v>
                  </c:pt>
                  <c:pt idx="8">
                    <c:v>0.74999999999999989</c:v>
                  </c:pt>
                  <c:pt idx="9">
                    <c:v>0.30500000000000149</c:v>
                  </c:pt>
                  <c:pt idx="10">
                    <c:v>0.30499999999999966</c:v>
                  </c:pt>
                  <c:pt idx="11">
                    <c:v>0.51999999999999957</c:v>
                  </c:pt>
                  <c:pt idx="12">
                    <c:v>0.40000000000000036</c:v>
                  </c:pt>
                  <c:pt idx="13">
                    <c:v>0.20000000000000104</c:v>
                  </c:pt>
                  <c:pt idx="14">
                    <c:v>0.34999999999999959</c:v>
                  </c:pt>
                  <c:pt idx="15">
                    <c:v>0.40000000000000036</c:v>
                  </c:pt>
                  <c:pt idx="16">
                    <c:v>0.65000000000000036</c:v>
                  </c:pt>
                  <c:pt idx="17">
                    <c:v>0.65000000000000036</c:v>
                  </c:pt>
                  <c:pt idx="18">
                    <c:v>4.9999999999998934E-2</c:v>
                  </c:pt>
                </c:numCache>
              </c:numRef>
            </c:plus>
            <c:minus>
              <c:numRef>
                <c:f>'B.W. 等 (2)'!$C$64:$U$64</c:f>
                <c:numCache>
                  <c:formatCode>General</c:formatCode>
                  <c:ptCount val="19"/>
                  <c:pt idx="0">
                    <c:v>0.32499999999999923</c:v>
                  </c:pt>
                  <c:pt idx="1">
                    <c:v>0.41999999999999987</c:v>
                  </c:pt>
                  <c:pt idx="2">
                    <c:v>0.43000000000000144</c:v>
                  </c:pt>
                  <c:pt idx="3">
                    <c:v>0.49000000000000105</c:v>
                  </c:pt>
                  <c:pt idx="4">
                    <c:v>0.72499999999999865</c:v>
                  </c:pt>
                  <c:pt idx="5">
                    <c:v>0.48500000000000032</c:v>
                  </c:pt>
                  <c:pt idx="6">
                    <c:v>0.43500000000000044</c:v>
                  </c:pt>
                  <c:pt idx="7">
                    <c:v>0.96000000000000074</c:v>
                  </c:pt>
                  <c:pt idx="8">
                    <c:v>0.74999999999999989</c:v>
                  </c:pt>
                  <c:pt idx="9">
                    <c:v>0.30500000000000149</c:v>
                  </c:pt>
                  <c:pt idx="10">
                    <c:v>0.30499999999999966</c:v>
                  </c:pt>
                  <c:pt idx="11">
                    <c:v>0.51999999999999957</c:v>
                  </c:pt>
                  <c:pt idx="12">
                    <c:v>0.40000000000000036</c:v>
                  </c:pt>
                  <c:pt idx="13">
                    <c:v>0.20000000000000104</c:v>
                  </c:pt>
                  <c:pt idx="14">
                    <c:v>0.34999999999999959</c:v>
                  </c:pt>
                  <c:pt idx="15">
                    <c:v>0.40000000000000036</c:v>
                  </c:pt>
                  <c:pt idx="16">
                    <c:v>0.65000000000000036</c:v>
                  </c:pt>
                  <c:pt idx="17">
                    <c:v>0.65000000000000036</c:v>
                  </c:pt>
                  <c:pt idx="18">
                    <c:v>4.9999999999998934E-2</c:v>
                  </c:pt>
                </c:numCache>
              </c:numRef>
            </c:minus>
            <c:spPr>
              <a:ln w="25400"/>
            </c:spPr>
          </c:errBars>
          <c:xVal>
            <c:numRef>
              <c:f>'B.W. 等 (2)'!$C$58:$U$58</c:f>
              <c:numCache>
                <c:formatCode>0</c:formatCode>
                <c:ptCount val="19"/>
                <c:pt idx="0">
                  <c:v>8.242857142857142</c:v>
                </c:pt>
                <c:pt idx="1">
                  <c:v>8.3857142857142861</c:v>
                </c:pt>
                <c:pt idx="2">
                  <c:v>8.5285714285714285</c:v>
                </c:pt>
                <c:pt idx="3">
                  <c:v>8.8142857142857132</c:v>
                </c:pt>
                <c:pt idx="4">
                  <c:v>9.3857142857142861</c:v>
                </c:pt>
                <c:pt idx="5">
                  <c:v>9.6714285714285708</c:v>
                </c:pt>
                <c:pt idx="6">
                  <c:v>9.9571428571428573</c:v>
                </c:pt>
                <c:pt idx="7">
                  <c:v>10.385714285714286</c:v>
                </c:pt>
                <c:pt idx="8">
                  <c:v>10.957142857142857</c:v>
                </c:pt>
                <c:pt idx="9">
                  <c:v>11.528571428571428</c:v>
                </c:pt>
                <c:pt idx="10">
                  <c:v>13.814285714285713</c:v>
                </c:pt>
                <c:pt idx="11">
                  <c:v>15.957142857142856</c:v>
                </c:pt>
                <c:pt idx="12">
                  <c:v>18.100000000000001</c:v>
                </c:pt>
                <c:pt idx="13">
                  <c:v>20.528571428571428</c:v>
                </c:pt>
                <c:pt idx="14">
                  <c:v>21.528571428571428</c:v>
                </c:pt>
                <c:pt idx="15">
                  <c:v>23.528571428571428</c:v>
                </c:pt>
                <c:pt idx="16">
                  <c:v>24.528571428571425</c:v>
                </c:pt>
                <c:pt idx="17">
                  <c:v>25.528571428571425</c:v>
                </c:pt>
                <c:pt idx="18">
                  <c:v>26.528571428571425</c:v>
                </c:pt>
              </c:numCache>
            </c:numRef>
          </c:xVal>
          <c:yVal>
            <c:numRef>
              <c:f>'B.W. 等 (2)'!$C$59:$U$59</c:f>
              <c:numCache>
                <c:formatCode>General</c:formatCode>
                <c:ptCount val="19"/>
                <c:pt idx="0">
                  <c:v>17.535</c:v>
                </c:pt>
                <c:pt idx="1">
                  <c:v>17.07</c:v>
                </c:pt>
                <c:pt idx="2">
                  <c:v>16.990000000000002</c:v>
                </c:pt>
                <c:pt idx="3">
                  <c:v>16.27</c:v>
                </c:pt>
                <c:pt idx="4">
                  <c:v>16.105</c:v>
                </c:pt>
                <c:pt idx="5">
                  <c:v>16.405000000000001</c:v>
                </c:pt>
                <c:pt idx="6">
                  <c:v>16.545000000000002</c:v>
                </c:pt>
                <c:pt idx="7">
                  <c:v>16.23</c:v>
                </c:pt>
                <c:pt idx="8">
                  <c:v>16.7</c:v>
                </c:pt>
                <c:pt idx="9">
                  <c:v>17.634999999999998</c:v>
                </c:pt>
                <c:pt idx="10">
                  <c:v>18.914999999999999</c:v>
                </c:pt>
                <c:pt idx="11">
                  <c:v>18.64</c:v>
                </c:pt>
                <c:pt idx="12">
                  <c:v>19.600000000000001</c:v>
                </c:pt>
                <c:pt idx="13">
                  <c:v>20.399999999999999</c:v>
                </c:pt>
                <c:pt idx="14">
                  <c:v>20.149999999999999</c:v>
                </c:pt>
                <c:pt idx="15">
                  <c:v>20.6</c:v>
                </c:pt>
                <c:pt idx="16">
                  <c:v>20.65</c:v>
                </c:pt>
                <c:pt idx="17">
                  <c:v>20.85</c:v>
                </c:pt>
                <c:pt idx="18">
                  <c:v>21.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73D-A14F-8A59-C71827652D9A}"/>
            </c:ext>
          </c:extLst>
        </c:ser>
        <c:ser>
          <c:idx val="1"/>
          <c:order val="1"/>
          <c:tx>
            <c:strRef>
              <c:f>'B.W. 等 (2)'!$B$60</c:f>
              <c:strCache>
                <c:ptCount val="1"/>
                <c:pt idx="0">
                  <c:v>KLKO</c:v>
                </c:pt>
              </c:strCache>
            </c:strRef>
          </c:tx>
          <c:spPr>
            <a:ln w="25400"/>
          </c:spPr>
          <c:errBars>
            <c:errDir val="y"/>
            <c:errBarType val="both"/>
            <c:errValType val="cust"/>
            <c:noEndCap val="0"/>
            <c:plus>
              <c:numRef>
                <c:f>'B.W. 等 (2)'!$C$65:$U$65</c:f>
                <c:numCache>
                  <c:formatCode>General</c:formatCode>
                  <c:ptCount val="19"/>
                  <c:pt idx="0">
                    <c:v>0.53500000000000014</c:v>
                  </c:pt>
                  <c:pt idx="1">
                    <c:v>1.2100000000000124</c:v>
                  </c:pt>
                  <c:pt idx="2">
                    <c:v>0.95000000000000007</c:v>
                  </c:pt>
                  <c:pt idx="3">
                    <c:v>0.68000000000000049</c:v>
                  </c:pt>
                  <c:pt idx="4">
                    <c:v>0.31500000000000039</c:v>
                  </c:pt>
                  <c:pt idx="5">
                    <c:v>5.4999999999999716E-2</c:v>
                  </c:pt>
                  <c:pt idx="6">
                    <c:v>0.29000000000000004</c:v>
                  </c:pt>
                  <c:pt idx="7">
                    <c:v>0.12999999999999989</c:v>
                  </c:pt>
                  <c:pt idx="8">
                    <c:v>0.25</c:v>
                  </c:pt>
                  <c:pt idx="9">
                    <c:v>0.98500000000000121</c:v>
                  </c:pt>
                  <c:pt idx="10">
                    <c:v>0.96999999999999975</c:v>
                  </c:pt>
                  <c:pt idx="11">
                    <c:v>0.93500000000000039</c:v>
                  </c:pt>
                  <c:pt idx="12">
                    <c:v>0.89999999999999947</c:v>
                  </c:pt>
                  <c:pt idx="13">
                    <c:v>1.5499999999999987</c:v>
                  </c:pt>
                  <c:pt idx="14">
                    <c:v>1.8500000000000034</c:v>
                  </c:pt>
                  <c:pt idx="15">
                    <c:v>1.3499999999999996</c:v>
                  </c:pt>
                  <c:pt idx="16">
                    <c:v>0.94999999999999918</c:v>
                  </c:pt>
                  <c:pt idx="17">
                    <c:v>1</c:v>
                  </c:pt>
                  <c:pt idx="18">
                    <c:v>1.2999999999999996</c:v>
                  </c:pt>
                </c:numCache>
              </c:numRef>
            </c:plus>
            <c:minus>
              <c:numRef>
                <c:f>'B.W. 等 (2)'!$C$65:$U$65</c:f>
                <c:numCache>
                  <c:formatCode>General</c:formatCode>
                  <c:ptCount val="19"/>
                  <c:pt idx="0">
                    <c:v>0.53500000000000014</c:v>
                  </c:pt>
                  <c:pt idx="1">
                    <c:v>1.2100000000000124</c:v>
                  </c:pt>
                  <c:pt idx="2">
                    <c:v>0.95000000000000007</c:v>
                  </c:pt>
                  <c:pt idx="3">
                    <c:v>0.68000000000000049</c:v>
                  </c:pt>
                  <c:pt idx="4">
                    <c:v>0.31500000000000039</c:v>
                  </c:pt>
                  <c:pt idx="5">
                    <c:v>5.4999999999999716E-2</c:v>
                  </c:pt>
                  <c:pt idx="6">
                    <c:v>0.29000000000000004</c:v>
                  </c:pt>
                  <c:pt idx="7">
                    <c:v>0.12999999999999989</c:v>
                  </c:pt>
                  <c:pt idx="8">
                    <c:v>0.25</c:v>
                  </c:pt>
                  <c:pt idx="9">
                    <c:v>0.98500000000000121</c:v>
                  </c:pt>
                  <c:pt idx="10">
                    <c:v>0.96999999999999975</c:v>
                  </c:pt>
                  <c:pt idx="11">
                    <c:v>0.93500000000000039</c:v>
                  </c:pt>
                  <c:pt idx="12">
                    <c:v>0.89999999999999947</c:v>
                  </c:pt>
                  <c:pt idx="13">
                    <c:v>1.5499999999999987</c:v>
                  </c:pt>
                  <c:pt idx="14">
                    <c:v>1.8500000000000034</c:v>
                  </c:pt>
                  <c:pt idx="15">
                    <c:v>1.3499999999999996</c:v>
                  </c:pt>
                  <c:pt idx="16">
                    <c:v>0.94999999999999918</c:v>
                  </c:pt>
                  <c:pt idx="17">
                    <c:v>1</c:v>
                  </c:pt>
                  <c:pt idx="18">
                    <c:v>1.2999999999999996</c:v>
                  </c:pt>
                </c:numCache>
              </c:numRef>
            </c:minus>
            <c:spPr>
              <a:ln w="22225"/>
            </c:spPr>
          </c:errBars>
          <c:xVal>
            <c:numRef>
              <c:f>'B.W. 等 (2)'!$C$58:$U$58</c:f>
              <c:numCache>
                <c:formatCode>0</c:formatCode>
                <c:ptCount val="19"/>
                <c:pt idx="0">
                  <c:v>8.242857142857142</c:v>
                </c:pt>
                <c:pt idx="1">
                  <c:v>8.3857142857142861</c:v>
                </c:pt>
                <c:pt idx="2">
                  <c:v>8.5285714285714285</c:v>
                </c:pt>
                <c:pt idx="3">
                  <c:v>8.8142857142857132</c:v>
                </c:pt>
                <c:pt idx="4">
                  <c:v>9.3857142857142861</c:v>
                </c:pt>
                <c:pt idx="5">
                  <c:v>9.6714285714285708</c:v>
                </c:pt>
                <c:pt idx="6">
                  <c:v>9.9571428571428573</c:v>
                </c:pt>
                <c:pt idx="7">
                  <c:v>10.385714285714286</c:v>
                </c:pt>
                <c:pt idx="8">
                  <c:v>10.957142857142857</c:v>
                </c:pt>
                <c:pt idx="9">
                  <c:v>11.528571428571428</c:v>
                </c:pt>
                <c:pt idx="10">
                  <c:v>13.814285714285713</c:v>
                </c:pt>
                <c:pt idx="11">
                  <c:v>15.957142857142856</c:v>
                </c:pt>
                <c:pt idx="12">
                  <c:v>18.100000000000001</c:v>
                </c:pt>
                <c:pt idx="13">
                  <c:v>20.528571428571428</c:v>
                </c:pt>
                <c:pt idx="14">
                  <c:v>21.528571428571428</c:v>
                </c:pt>
                <c:pt idx="15">
                  <c:v>23.528571428571428</c:v>
                </c:pt>
                <c:pt idx="16">
                  <c:v>24.528571428571425</c:v>
                </c:pt>
                <c:pt idx="17">
                  <c:v>25.528571428571425</c:v>
                </c:pt>
                <c:pt idx="18">
                  <c:v>26.528571428571425</c:v>
                </c:pt>
              </c:numCache>
            </c:numRef>
          </c:xVal>
          <c:yVal>
            <c:numRef>
              <c:f>'B.W. 等 (2)'!$C$60:$U$60</c:f>
              <c:numCache>
                <c:formatCode>General</c:formatCode>
                <c:ptCount val="19"/>
                <c:pt idx="0">
                  <c:v>11.195</c:v>
                </c:pt>
                <c:pt idx="1">
                  <c:v>11.86</c:v>
                </c:pt>
                <c:pt idx="2">
                  <c:v>11.89</c:v>
                </c:pt>
                <c:pt idx="3">
                  <c:v>11.969999999999999</c:v>
                </c:pt>
                <c:pt idx="4">
                  <c:v>12.844999999999999</c:v>
                </c:pt>
                <c:pt idx="5">
                  <c:v>12.955</c:v>
                </c:pt>
                <c:pt idx="6">
                  <c:v>13.079999999999998</c:v>
                </c:pt>
                <c:pt idx="7">
                  <c:v>14.05</c:v>
                </c:pt>
                <c:pt idx="8">
                  <c:v>14.55</c:v>
                </c:pt>
                <c:pt idx="9">
                  <c:v>15.775</c:v>
                </c:pt>
                <c:pt idx="10">
                  <c:v>15.64</c:v>
                </c:pt>
                <c:pt idx="11">
                  <c:v>16.115000000000002</c:v>
                </c:pt>
                <c:pt idx="12">
                  <c:v>16.8</c:v>
                </c:pt>
                <c:pt idx="13">
                  <c:v>15.85</c:v>
                </c:pt>
                <c:pt idx="14">
                  <c:v>15.75</c:v>
                </c:pt>
                <c:pt idx="15">
                  <c:v>15.85</c:v>
                </c:pt>
                <c:pt idx="16">
                  <c:v>15.45</c:v>
                </c:pt>
                <c:pt idx="17">
                  <c:v>15.3</c:v>
                </c:pt>
                <c:pt idx="18">
                  <c:v>14.1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73D-A14F-8A59-C71827652D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7025408"/>
        <c:axId val="267666176"/>
      </c:scatterChart>
      <c:valAx>
        <c:axId val="267025408"/>
        <c:scaling>
          <c:orientation val="minMax"/>
          <c:min val="8"/>
        </c:scaling>
        <c:delete val="0"/>
        <c:axPos val="b"/>
        <c:numFmt formatCode="0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666176"/>
        <c:crosses val="autoZero"/>
        <c:crossBetween val="midCat"/>
      </c:valAx>
      <c:valAx>
        <c:axId val="267666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702540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7050620165235195"/>
          <c:y val="0.27438552393443699"/>
          <c:w val="0.16459330207326089"/>
          <c:h val="0.18443529762603375"/>
        </c:manualLayout>
      </c:layout>
      <c:overlay val="0"/>
      <c:txPr>
        <a:bodyPr/>
        <a:lstStyle/>
        <a:p>
          <a:pPr>
            <a:defRPr b="1" i="0">
              <a:latin typeface="Helvetica" pitchFamily="2" charset="0"/>
            </a:defRPr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3734045780824495E-2"/>
          <c:y val="6.2457359551415778E-2"/>
          <c:w val="0.71195430660843739"/>
          <c:h val="0.826066312994975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34</c:f>
              <c:strCache>
                <c:ptCount val="1"/>
                <c:pt idx="0">
                  <c:v>0 days</c:v>
                </c:pt>
              </c:strCache>
            </c:strRef>
          </c:tx>
          <c:spPr>
            <a:noFill/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H$34:$H$35</c:f>
                <c:numCache>
                  <c:formatCode>General</c:formatCode>
                  <c:ptCount val="2"/>
                  <c:pt idx="0">
                    <c:v>0.82624878971166815</c:v>
                  </c:pt>
                  <c:pt idx="1">
                    <c:v>0.31585518833794946</c:v>
                  </c:pt>
                </c:numCache>
              </c:numRef>
            </c:plus>
            <c:minus>
              <c:numRef>
                <c:f>Sheet1!$H$34:$H$35</c:f>
                <c:numCache>
                  <c:formatCode>General</c:formatCode>
                  <c:ptCount val="2"/>
                  <c:pt idx="0">
                    <c:v>0.82624878971166815</c:v>
                  </c:pt>
                  <c:pt idx="1">
                    <c:v>0.31585518833794946</c:v>
                  </c:pt>
                </c:numCache>
              </c:numRef>
            </c:minus>
            <c:spPr>
              <a:ln w="25400"/>
            </c:spPr>
          </c:errBars>
          <c:cat>
            <c:strRef>
              <c:f>Sheet1!$D$33:$E$33</c:f>
              <c:strCache>
                <c:ptCount val="2"/>
                <c:pt idx="0">
                  <c:v>WT</c:v>
                </c:pt>
                <c:pt idx="1">
                  <c:v>KLKO</c:v>
                </c:pt>
              </c:strCache>
            </c:strRef>
          </c:cat>
          <c:val>
            <c:numRef>
              <c:f>Sheet1!$D$34:$E$34</c:f>
              <c:numCache>
                <c:formatCode>General</c:formatCode>
                <c:ptCount val="2"/>
                <c:pt idx="0">
                  <c:v>7.4282500000000002</c:v>
                </c:pt>
                <c:pt idx="1">
                  <c:v>10.784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61-454B-B9CA-0A0A8B2DC544}"/>
            </c:ext>
          </c:extLst>
        </c:ser>
        <c:ser>
          <c:idx val="1"/>
          <c:order val="1"/>
          <c:tx>
            <c:strRef>
              <c:f>Sheet1!$C$35</c:f>
              <c:strCache>
                <c:ptCount val="1"/>
                <c:pt idx="0">
                  <c:v>8 days</c:v>
                </c:pt>
              </c:strCache>
            </c:strRef>
          </c:tx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34:$I$35</c:f>
                <c:numCache>
                  <c:formatCode>General</c:formatCode>
                  <c:ptCount val="2"/>
                  <c:pt idx="0">
                    <c:v>1.3724661906380198</c:v>
                  </c:pt>
                  <c:pt idx="1">
                    <c:v>1.4928177309295916</c:v>
                  </c:pt>
                </c:numCache>
              </c:numRef>
            </c:plus>
            <c:minus>
              <c:numRef>
                <c:f>Sheet1!$I$34:$I$35</c:f>
                <c:numCache>
                  <c:formatCode>General</c:formatCode>
                  <c:ptCount val="2"/>
                  <c:pt idx="0">
                    <c:v>1.3724661906380198</c:v>
                  </c:pt>
                  <c:pt idx="1">
                    <c:v>1.4928177309295916</c:v>
                  </c:pt>
                </c:numCache>
              </c:numRef>
            </c:minus>
            <c:spPr>
              <a:ln w="25400"/>
            </c:spPr>
          </c:errBars>
          <c:cat>
            <c:strRef>
              <c:f>Sheet1!$D$33:$E$33</c:f>
              <c:strCache>
                <c:ptCount val="2"/>
                <c:pt idx="0">
                  <c:v>WT</c:v>
                </c:pt>
                <c:pt idx="1">
                  <c:v>KLKO</c:v>
                </c:pt>
              </c:strCache>
            </c:strRef>
          </c:cat>
          <c:val>
            <c:numRef>
              <c:f>Sheet1!$D$35:$E$35</c:f>
              <c:numCache>
                <c:formatCode>General</c:formatCode>
                <c:ptCount val="2"/>
                <c:pt idx="0">
                  <c:v>4.101</c:v>
                </c:pt>
                <c:pt idx="1">
                  <c:v>5.585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061-454B-B9CA-0A0A8B2DC5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7700864"/>
        <c:axId val="267706752"/>
      </c:barChart>
      <c:catAx>
        <c:axId val="2677008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 b="1">
                <a:latin typeface="Helvetica" pitchFamily="2" charset="0"/>
              </a:defRPr>
            </a:pPr>
            <a:endParaRPr lang="ja-JP"/>
          </a:p>
        </c:txPr>
        <c:crossAx val="267706752"/>
        <c:crosses val="autoZero"/>
        <c:auto val="1"/>
        <c:lblAlgn val="ctr"/>
        <c:lblOffset val="100"/>
        <c:noMultiLvlLbl val="0"/>
      </c:catAx>
      <c:valAx>
        <c:axId val="2677067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 b="1">
                <a:latin typeface="Helvetica" pitchFamily="2" charset="0"/>
              </a:defRPr>
            </a:pPr>
            <a:endParaRPr lang="ja-JP"/>
          </a:p>
        </c:txPr>
        <c:crossAx val="2677008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344598568979474"/>
          <c:y val="0.40972072573931717"/>
          <c:w val="0.18660674107889622"/>
          <c:h val="0.1805585485213656"/>
        </c:manualLayout>
      </c:layout>
      <c:overlay val="0"/>
      <c:txPr>
        <a:bodyPr/>
        <a:lstStyle/>
        <a:p>
          <a:pPr>
            <a:defRPr sz="1000" b="0" i="0">
              <a:latin typeface="Helvetica" pitchFamily="2" charset="0"/>
            </a:defRPr>
          </a:pPr>
          <a:endParaRPr lang="ja-JP"/>
        </a:p>
      </c:txPr>
    </c:legend>
    <c:plotVisOnly val="1"/>
    <c:dispBlanksAs val="gap"/>
    <c:showDLblsOverMax val="0"/>
  </c:chart>
  <c:spPr>
    <a:ln w="25400"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146072639468575"/>
          <c:y val="5.4408193087160599E-2"/>
          <c:w val="0.85196928225436586"/>
          <c:h val="0.714934562171778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heet1 (3)'!$N$16:$S$16</c:f>
                <c:numCache>
                  <c:formatCode>General</c:formatCode>
                  <c:ptCount val="6"/>
                  <c:pt idx="0">
                    <c:v>1.788593269139918E-3</c:v>
                  </c:pt>
                  <c:pt idx="1">
                    <c:v>1.3652325524374755E-2</c:v>
                  </c:pt>
                  <c:pt idx="2">
                    <c:v>4.0903056002997767E-3</c:v>
                  </c:pt>
                  <c:pt idx="3">
                    <c:v>1.1757343292522007E-3</c:v>
                  </c:pt>
                  <c:pt idx="4">
                    <c:v>8.1960126435011941E-3</c:v>
                  </c:pt>
                  <c:pt idx="5">
                    <c:v>1.1538061000558228E-3</c:v>
                  </c:pt>
                </c:numCache>
              </c:numRef>
            </c:plus>
            <c:minus>
              <c:numRef>
                <c:f>'Sheet1 (3)'!$N$16:$S$16</c:f>
                <c:numCache>
                  <c:formatCode>General</c:formatCode>
                  <c:ptCount val="6"/>
                  <c:pt idx="0">
                    <c:v>1.788593269139918E-3</c:v>
                  </c:pt>
                  <c:pt idx="1">
                    <c:v>1.3652325524374755E-2</c:v>
                  </c:pt>
                  <c:pt idx="2">
                    <c:v>4.0903056002997767E-3</c:v>
                  </c:pt>
                  <c:pt idx="3">
                    <c:v>1.1757343292522007E-3</c:v>
                  </c:pt>
                  <c:pt idx="4">
                    <c:v>8.1960126435011941E-3</c:v>
                  </c:pt>
                  <c:pt idx="5">
                    <c:v>1.1538061000558228E-3</c:v>
                  </c:pt>
                </c:numCache>
              </c:numRef>
            </c:minus>
            <c:spPr>
              <a:ln w="25400"/>
            </c:spPr>
          </c:errBars>
          <c:cat>
            <c:strRef>
              <c:f>'Sheet1 (3)'!$N$2:$S$2</c:f>
              <c:strCache>
                <c:ptCount val="6"/>
                <c:pt idx="0">
                  <c:v>WT</c:v>
                </c:pt>
                <c:pt idx="1">
                  <c:v>KLKO</c:v>
                </c:pt>
                <c:pt idx="2">
                  <c:v>KL2aDKO</c:v>
                </c:pt>
                <c:pt idx="3">
                  <c:v>Npt2aKO</c:v>
                </c:pt>
                <c:pt idx="4">
                  <c:v>KL2cDKO</c:v>
                </c:pt>
                <c:pt idx="5">
                  <c:v>Npt2cKO</c:v>
                </c:pt>
              </c:strCache>
            </c:strRef>
          </c:cat>
          <c:val>
            <c:numRef>
              <c:f>'Sheet1 (3)'!$N$12:$S$12</c:f>
              <c:numCache>
                <c:formatCode>General</c:formatCode>
                <c:ptCount val="6"/>
                <c:pt idx="0">
                  <c:v>5.588533617077022E-3</c:v>
                </c:pt>
                <c:pt idx="1">
                  <c:v>8.6016904601199637E-2</c:v>
                </c:pt>
                <c:pt idx="2">
                  <c:v>3.2981433051173369E-2</c:v>
                </c:pt>
                <c:pt idx="3">
                  <c:v>1.0360813989679031E-2</c:v>
                </c:pt>
                <c:pt idx="4">
                  <c:v>3.9567163328703595E-2</c:v>
                </c:pt>
                <c:pt idx="5">
                  <c:v>4.42148820338800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1B-D141-AA3A-2A639EDA91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7518720"/>
        <c:axId val="267520256"/>
      </c:barChart>
      <c:catAx>
        <c:axId val="2675187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-240000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Helvetica" pitchFamily="2" charset="0"/>
                <a:ea typeface="ＭＳ Ｐゴシック"/>
                <a:cs typeface="ＭＳ Ｐゴシック"/>
              </a:defRPr>
            </a:pPr>
            <a:endParaRPr lang="ja-JP"/>
          </a:p>
        </c:txPr>
        <c:crossAx val="267520256"/>
        <c:crosses val="autoZero"/>
        <c:auto val="1"/>
        <c:lblAlgn val="ctr"/>
        <c:lblOffset val="100"/>
        <c:noMultiLvlLbl val="0"/>
      </c:catAx>
      <c:valAx>
        <c:axId val="267520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Helvetica" pitchFamily="2" charset="0"/>
                <a:ea typeface="ＭＳ Ｐゴシック"/>
                <a:cs typeface="ＭＳ Ｐゴシック"/>
              </a:defRPr>
            </a:pPr>
            <a:endParaRPr lang="ja-JP"/>
          </a:p>
        </c:txPr>
        <c:crossAx val="26751872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はずしtekuwaeta version (2)'!$T$40:$Y$40</c:f>
                <c:numCache>
                  <c:formatCode>General</c:formatCode>
                  <c:ptCount val="6"/>
                  <c:pt idx="0">
                    <c:v>2.662355124647648E-3</c:v>
                  </c:pt>
                  <c:pt idx="1">
                    <c:v>6.920616696249359E-4</c:v>
                  </c:pt>
                  <c:pt idx="2">
                    <c:v>3.9914885682696479E-4</c:v>
                  </c:pt>
                  <c:pt idx="3">
                    <c:v>3.4814937087989219E-4</c:v>
                  </c:pt>
                  <c:pt idx="4">
                    <c:v>1.4418904452760159E-3</c:v>
                  </c:pt>
                  <c:pt idx="5">
                    <c:v>4.491228597069238E-4</c:v>
                  </c:pt>
                </c:numCache>
              </c:numRef>
            </c:plus>
            <c:minus>
              <c:numRef>
                <c:f>'はずしtekuwaeta version (2)'!$T$40:$Y$40</c:f>
                <c:numCache>
                  <c:formatCode>General</c:formatCode>
                  <c:ptCount val="6"/>
                  <c:pt idx="0">
                    <c:v>2.662355124647648E-3</c:v>
                  </c:pt>
                  <c:pt idx="1">
                    <c:v>6.920616696249359E-4</c:v>
                  </c:pt>
                  <c:pt idx="2">
                    <c:v>3.9914885682696479E-4</c:v>
                  </c:pt>
                  <c:pt idx="3">
                    <c:v>3.4814937087989219E-4</c:v>
                  </c:pt>
                  <c:pt idx="4">
                    <c:v>1.4418904452760159E-3</c:v>
                  </c:pt>
                  <c:pt idx="5">
                    <c:v>4.491228597069238E-4</c:v>
                  </c:pt>
                </c:numCache>
              </c:numRef>
            </c:minus>
            <c:spPr>
              <a:ln w="254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はずしtekuwaeta version (2)'!$T$28:$Y$28</c:f>
              <c:strCache>
                <c:ptCount val="6"/>
                <c:pt idx="0">
                  <c:v>WT</c:v>
                </c:pt>
                <c:pt idx="1">
                  <c:v>KLKO</c:v>
                </c:pt>
                <c:pt idx="2">
                  <c:v>KL2aDKO</c:v>
                </c:pt>
                <c:pt idx="3">
                  <c:v>Npt2aKO</c:v>
                </c:pt>
                <c:pt idx="4">
                  <c:v>KL2cDKO</c:v>
                </c:pt>
                <c:pt idx="5">
                  <c:v>Npt2cKO</c:v>
                </c:pt>
              </c:strCache>
            </c:strRef>
          </c:cat>
          <c:val>
            <c:numRef>
              <c:f>'はずしtekuwaeta version (2)'!$T$36:$Y$36</c:f>
              <c:numCache>
                <c:formatCode>General</c:formatCode>
                <c:ptCount val="6"/>
                <c:pt idx="0">
                  <c:v>6.9218116790737728E-3</c:v>
                </c:pt>
                <c:pt idx="1">
                  <c:v>1.6277355231600862E-3</c:v>
                </c:pt>
                <c:pt idx="2">
                  <c:v>2.4280685272585166E-3</c:v>
                </c:pt>
                <c:pt idx="3">
                  <c:v>3.5307744785273696E-3</c:v>
                </c:pt>
                <c:pt idx="4">
                  <c:v>4.2980283045132286E-3</c:v>
                </c:pt>
                <c:pt idx="5">
                  <c:v>3.720006440398276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29-664D-921A-6943DA2B73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7553024"/>
        <c:axId val="267558912"/>
      </c:barChart>
      <c:catAx>
        <c:axId val="267553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  <a:prstDash val="solid"/>
          </a:ln>
        </c:spPr>
        <c:txPr>
          <a:bodyPr rot="-264000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Helvetica" pitchFamily="2" charset="0"/>
                <a:ea typeface="ＭＳ Ｐゴシック"/>
                <a:cs typeface="ＭＳ Ｐゴシック"/>
              </a:defRPr>
            </a:pPr>
            <a:endParaRPr lang="ja-JP"/>
          </a:p>
        </c:txPr>
        <c:crossAx val="267558912"/>
        <c:crosses val="autoZero"/>
        <c:auto val="1"/>
        <c:lblAlgn val="ctr"/>
        <c:lblOffset val="100"/>
        <c:noMultiLvlLbl val="0"/>
      </c:catAx>
      <c:valAx>
        <c:axId val="2675589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Helvetica" pitchFamily="2" charset="0"/>
                <a:ea typeface="ＭＳ Ｐゴシック"/>
                <a:cs typeface="ＭＳ Ｐゴシック"/>
              </a:defRPr>
            </a:pPr>
            <a:endParaRPr lang="ja-JP"/>
          </a:p>
        </c:txPr>
        <c:crossAx val="267553024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2644413628744477"/>
          <c:y val="5.4408171897108192E-2"/>
          <c:w val="0.83692142765734712"/>
          <c:h val="0.692117513862010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8wk Male (2)'!$N$31:$S$31</c:f>
                <c:numCache>
                  <c:formatCode>General</c:formatCode>
                  <c:ptCount val="6"/>
                  <c:pt idx="0">
                    <c:v>1.6441354088414802E-2</c:v>
                  </c:pt>
                  <c:pt idx="1">
                    <c:v>1.06678162531995E-2</c:v>
                  </c:pt>
                  <c:pt idx="2">
                    <c:v>8.3554348367181799E-2</c:v>
                  </c:pt>
                  <c:pt idx="3">
                    <c:v>6.8955984605422196E-2</c:v>
                  </c:pt>
                  <c:pt idx="4">
                    <c:v>4.3789064319333999E-2</c:v>
                  </c:pt>
                  <c:pt idx="5">
                    <c:v>2.51083348937522E-2</c:v>
                  </c:pt>
                </c:numCache>
              </c:numRef>
            </c:plus>
            <c:minus>
              <c:numRef>
                <c:f>'8wk Male (2)'!$N$31:$S$31</c:f>
                <c:numCache>
                  <c:formatCode>General</c:formatCode>
                  <c:ptCount val="6"/>
                  <c:pt idx="0">
                    <c:v>1.6441354088414802E-2</c:v>
                  </c:pt>
                  <c:pt idx="1">
                    <c:v>1.06678162531995E-2</c:v>
                  </c:pt>
                  <c:pt idx="2">
                    <c:v>8.3554348367181799E-2</c:v>
                  </c:pt>
                  <c:pt idx="3">
                    <c:v>6.8955984605422196E-2</c:v>
                  </c:pt>
                  <c:pt idx="4">
                    <c:v>4.3789064319333999E-2</c:v>
                  </c:pt>
                  <c:pt idx="5">
                    <c:v>2.51083348937522E-2</c:v>
                  </c:pt>
                </c:numCache>
              </c:numRef>
            </c:minus>
            <c:spPr>
              <a:ln w="25400"/>
            </c:spPr>
          </c:errBars>
          <c:cat>
            <c:strRef>
              <c:f>'8wk Male (2)'!$N$29:$S$29</c:f>
              <c:strCache>
                <c:ptCount val="6"/>
                <c:pt idx="0">
                  <c:v>WT</c:v>
                </c:pt>
                <c:pt idx="1">
                  <c:v>KLKO</c:v>
                </c:pt>
                <c:pt idx="2">
                  <c:v>KL2aDKO</c:v>
                </c:pt>
                <c:pt idx="3">
                  <c:v>Npt2aKO</c:v>
                </c:pt>
                <c:pt idx="4">
                  <c:v>KL2cDKO</c:v>
                </c:pt>
                <c:pt idx="5">
                  <c:v>Npt2cKO</c:v>
                </c:pt>
              </c:strCache>
            </c:strRef>
          </c:cat>
          <c:val>
            <c:numRef>
              <c:f>'8wk Male (2)'!$N$30:$S$30</c:f>
              <c:numCache>
                <c:formatCode>General</c:formatCode>
                <c:ptCount val="6"/>
                <c:pt idx="0">
                  <c:v>1.193240024293525</c:v>
                </c:pt>
                <c:pt idx="1">
                  <c:v>1.2000607587410399</c:v>
                </c:pt>
                <c:pt idx="2">
                  <c:v>1.399332048210018</c:v>
                </c:pt>
                <c:pt idx="3">
                  <c:v>1.387017382336116</c:v>
                </c:pt>
                <c:pt idx="4">
                  <c:v>1.2573377550349449</c:v>
                </c:pt>
                <c:pt idx="5">
                  <c:v>1.2056122467786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E1-D243-8AA6-97D6A7359D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7620352"/>
        <c:axId val="267621888"/>
      </c:barChart>
      <c:catAx>
        <c:axId val="2676203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 rot="-2640000"/>
          <a:lstStyle/>
          <a:p>
            <a:pPr>
              <a:defRPr sz="1000" b="1">
                <a:latin typeface="Helvetica" pitchFamily="2" charset="0"/>
                <a:cs typeface="Arial"/>
              </a:defRPr>
            </a:pPr>
            <a:endParaRPr lang="ja-JP"/>
          </a:p>
        </c:txPr>
        <c:crossAx val="267621888"/>
        <c:crosses val="autoZero"/>
        <c:auto val="1"/>
        <c:lblAlgn val="ctr"/>
        <c:lblOffset val="100"/>
        <c:noMultiLvlLbl val="0"/>
      </c:catAx>
      <c:valAx>
        <c:axId val="26762188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Helvetica" pitchFamily="2" charset="0"/>
              </a:defRPr>
            </a:pPr>
            <a:endParaRPr lang="ja-JP"/>
          </a:p>
        </c:txPr>
        <c:crossAx val="2676203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90093589859036"/>
          <c:y val="5.4408193087160599E-2"/>
          <c:w val="0.83252907275046117"/>
          <c:h val="0.706955992067386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a代謝ケージ5wks,8wksまとめ 2倍した値(3)'!$BV$33:$CA$33</c:f>
                <c:numCache>
                  <c:formatCode>General</c:formatCode>
                  <c:ptCount val="6"/>
                  <c:pt idx="0">
                    <c:v>3.3128938758117198E-2</c:v>
                  </c:pt>
                  <c:pt idx="1">
                    <c:v>6.7648218021159015E-2</c:v>
                  </c:pt>
                  <c:pt idx="2">
                    <c:v>0.37931372879163955</c:v>
                  </c:pt>
                  <c:pt idx="3">
                    <c:v>0.44050740618590667</c:v>
                  </c:pt>
                  <c:pt idx="4">
                    <c:v>9.6393534660625751E-2</c:v>
                  </c:pt>
                  <c:pt idx="5">
                    <c:v>6.1915414862213421E-2</c:v>
                  </c:pt>
                </c:numCache>
              </c:numRef>
            </c:plus>
            <c:minus>
              <c:numRef>
                <c:f>'Ca代謝ケージ5wks,8wksまとめ 2倍した値(3)'!$BV$33:$CA$33</c:f>
                <c:numCache>
                  <c:formatCode>General</c:formatCode>
                  <c:ptCount val="6"/>
                  <c:pt idx="0">
                    <c:v>3.3128938758117198E-2</c:v>
                  </c:pt>
                  <c:pt idx="1">
                    <c:v>6.7648218021159015E-2</c:v>
                  </c:pt>
                  <c:pt idx="2">
                    <c:v>0.37931372879163955</c:v>
                  </c:pt>
                  <c:pt idx="3">
                    <c:v>0.44050740618590667</c:v>
                  </c:pt>
                  <c:pt idx="4">
                    <c:v>9.6393534660625751E-2</c:v>
                  </c:pt>
                  <c:pt idx="5">
                    <c:v>6.1915414862213421E-2</c:v>
                  </c:pt>
                </c:numCache>
              </c:numRef>
            </c:minus>
            <c:spPr>
              <a:ln w="28575"/>
            </c:spPr>
          </c:errBars>
          <c:cat>
            <c:strRef>
              <c:f>'Ca代謝ケージ5wks,8wksまとめ 2倍した値(3)'!$BV$3:$CA$3</c:f>
              <c:strCache>
                <c:ptCount val="6"/>
                <c:pt idx="0">
                  <c:v>WT</c:v>
                </c:pt>
                <c:pt idx="1">
                  <c:v>KLKO</c:v>
                </c:pt>
                <c:pt idx="2">
                  <c:v>KL2aDKO</c:v>
                </c:pt>
                <c:pt idx="3">
                  <c:v>Npt2aKO</c:v>
                </c:pt>
                <c:pt idx="4">
                  <c:v>KL2cDKO</c:v>
                </c:pt>
                <c:pt idx="5">
                  <c:v>Npt2cKO</c:v>
                </c:pt>
              </c:strCache>
            </c:strRef>
          </c:cat>
          <c:val>
            <c:numRef>
              <c:f>'Ca代謝ケージ5wks,8wksまとめ 2倍した値(3)'!$BV$29:$CA$29</c:f>
              <c:numCache>
                <c:formatCode>General</c:formatCode>
                <c:ptCount val="6"/>
                <c:pt idx="0">
                  <c:v>0.2205525666666667</c:v>
                </c:pt>
                <c:pt idx="1">
                  <c:v>0.37933294000000001</c:v>
                </c:pt>
                <c:pt idx="2">
                  <c:v>3.5898672999999994</c:v>
                </c:pt>
                <c:pt idx="3">
                  <c:v>1.8216319199999997</c:v>
                </c:pt>
                <c:pt idx="4">
                  <c:v>0.42228748571428565</c:v>
                </c:pt>
                <c:pt idx="5">
                  <c:v>0.2642086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9A-BA49-AC1E-30C862E9C4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047872"/>
        <c:axId val="268049408"/>
      </c:barChart>
      <c:catAx>
        <c:axId val="268047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-2640000" vert="horz"/>
          <a:lstStyle/>
          <a:p>
            <a:pPr>
              <a:defRPr/>
            </a:pPr>
            <a:endParaRPr lang="ja-JP"/>
          </a:p>
        </c:txPr>
        <c:crossAx val="268049408"/>
        <c:crosses val="autoZero"/>
        <c:auto val="1"/>
        <c:lblAlgn val="ctr"/>
        <c:lblOffset val="100"/>
        <c:noMultiLvlLbl val="0"/>
      </c:catAx>
      <c:valAx>
        <c:axId val="268049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/>
            </a:pPr>
            <a:endParaRPr lang="ja-JP"/>
          </a:p>
        </c:txPr>
        <c:crossAx val="2680478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Helvetica" pitchFamily="2" charset="0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週齢まとめ訂正後'!$W$30:$X$30</c:f>
                <c:numCache>
                  <c:formatCode>General</c:formatCode>
                  <c:ptCount val="2"/>
                  <c:pt idx="0">
                    <c:v>0.19809272427560082</c:v>
                  </c:pt>
                  <c:pt idx="1">
                    <c:v>0.11854631070872211</c:v>
                  </c:pt>
                </c:numCache>
              </c:numRef>
            </c:plus>
            <c:minus>
              <c:numRef>
                <c:f>'5週齢まとめ訂正後'!$W$30:$X$30</c:f>
                <c:numCache>
                  <c:formatCode>General</c:formatCode>
                  <c:ptCount val="2"/>
                  <c:pt idx="0">
                    <c:v>0.19809272427560082</c:v>
                  </c:pt>
                  <c:pt idx="1">
                    <c:v>0.11854631070872211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5週齢まとめ訂正後'!$W$19:$X$19</c:f>
              <c:strCache>
                <c:ptCount val="2"/>
                <c:pt idx="0">
                  <c:v>WT</c:v>
                </c:pt>
                <c:pt idx="1">
                  <c:v>KLKO</c:v>
                </c:pt>
              </c:strCache>
            </c:strRef>
          </c:cat>
          <c:val>
            <c:numRef>
              <c:f>'5週齢まとめ訂正後'!$W$26:$X$26</c:f>
              <c:numCache>
                <c:formatCode>General</c:formatCode>
                <c:ptCount val="2"/>
                <c:pt idx="0">
                  <c:v>1</c:v>
                </c:pt>
                <c:pt idx="1">
                  <c:v>0.775286722978047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F6-144E-A490-8F2F5D3301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108160"/>
        <c:axId val="268109696"/>
      </c:barChart>
      <c:catAx>
        <c:axId val="2681081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8109696"/>
        <c:crosses val="autoZero"/>
        <c:auto val="1"/>
        <c:lblAlgn val="ctr"/>
        <c:lblOffset val="100"/>
        <c:noMultiLvlLbl val="0"/>
      </c:catAx>
      <c:valAx>
        <c:axId val="268109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Helvetica" pitchFamily="2" charset="0"/>
              </a:defRPr>
            </a:pPr>
            <a:endParaRPr lang="ja-JP"/>
          </a:p>
        </c:txPr>
        <c:crossAx val="2681081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FF5997-9AC7-2643-B16C-FCCEB56D1716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ED189F-47FD-4547-BABF-17ED0FD522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3616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717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881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7131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55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5170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464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6162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009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9564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122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670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9D07B-A9F6-0E41-8432-5D88B1ADD3CF}" type="datetimeFigureOut">
              <a:rPr kumimoji="1" lang="ja-JP" altLang="en-US" smtClean="0"/>
              <a:t>2019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F115A-BDCC-9541-B4F4-805F578BF6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9338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5.xml"/><Relationship Id="rId3" Type="http://schemas.openxmlformats.org/officeDocument/2006/relationships/chart" Target="../charts/chart10.xml"/><Relationship Id="rId7" Type="http://schemas.openxmlformats.org/officeDocument/2006/relationships/chart" Target="../charts/chart14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3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Relationship Id="rId9" Type="http://schemas.openxmlformats.org/officeDocument/2006/relationships/chart" Target="../charts/chart16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image" Target="../media/image1.png"/><Relationship Id="rId7" Type="http://schemas.openxmlformats.org/officeDocument/2006/relationships/chart" Target="../charts/chart19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8.xml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chart" Target="../charts/chart2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6849337-AE23-D440-A88B-854017DF78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9482598"/>
              </p:ext>
            </p:extLst>
          </p:nvPr>
        </p:nvGraphicFramePr>
        <p:xfrm>
          <a:off x="1764822" y="1529595"/>
          <a:ext cx="1556758" cy="22367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A1AB6D4A-51C7-2947-960D-12F578C433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4912469"/>
              </p:ext>
            </p:extLst>
          </p:nvPr>
        </p:nvGraphicFramePr>
        <p:xfrm>
          <a:off x="3874390" y="1550393"/>
          <a:ext cx="1556758" cy="22367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8350DCE-23CA-E048-8B74-B88505F0CD58}"/>
              </a:ext>
            </a:extLst>
          </p:cNvPr>
          <p:cNvSpPr txBox="1"/>
          <p:nvPr/>
        </p:nvSpPr>
        <p:spPr>
          <a:xfrm>
            <a:off x="2040485" y="1375713"/>
            <a:ext cx="1281096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pPr algn="ctr"/>
            <a:r>
              <a:rPr lang="en-US" altLang="ja-JP" sz="1400" b="1" dirty="0">
                <a:latin typeface="Helvetica" pitchFamily="2" charset="0"/>
                <a:cs typeface="Arial"/>
              </a:rPr>
              <a:t>Npt2a</a:t>
            </a:r>
            <a:r>
              <a:rPr lang="ja-JP" altLang="en-US" sz="1400" b="1">
                <a:latin typeface="Helvetica" pitchFamily="2" charset="0"/>
                <a:cs typeface="Arial"/>
              </a:rPr>
              <a:t> </a:t>
            </a:r>
            <a:r>
              <a:rPr lang="en-US" altLang="ja-JP" sz="1400" b="1" dirty="0">
                <a:latin typeface="Helvetica" pitchFamily="2" charset="0"/>
                <a:cs typeface="Arial"/>
              </a:rPr>
              <a:t>mRNA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DE87772-5B74-A14F-9F28-694B0544F6E7}"/>
              </a:ext>
            </a:extLst>
          </p:cNvPr>
          <p:cNvSpPr txBox="1"/>
          <p:nvPr/>
        </p:nvSpPr>
        <p:spPr>
          <a:xfrm>
            <a:off x="4264012" y="1375713"/>
            <a:ext cx="1281096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pPr algn="ctr"/>
            <a:r>
              <a:rPr lang="en-US" altLang="ja-JP" sz="1400" b="1" dirty="0">
                <a:latin typeface="Helvetica" pitchFamily="2" charset="0"/>
                <a:cs typeface="Arial"/>
              </a:rPr>
              <a:t>Npt2c mRNA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0CE02D4-F0F0-3044-A8E6-F74FD374E4A6}"/>
              </a:ext>
            </a:extLst>
          </p:cNvPr>
          <p:cNvSpPr txBox="1"/>
          <p:nvPr/>
        </p:nvSpPr>
        <p:spPr>
          <a:xfrm>
            <a:off x="303045" y="275458"/>
            <a:ext cx="1339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</a:t>
            </a:r>
            <a:r>
              <a:rPr kumimoji="1" lang="ja-JP" altLang="en-US"/>
              <a:t> </a:t>
            </a:r>
            <a:r>
              <a:rPr kumimoji="1" lang="en-US" altLang="ja-JP" dirty="0"/>
              <a:t>Figure 1</a:t>
            </a:r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EC89602-C37F-6D46-9BC6-CD9A95534AEA}"/>
              </a:ext>
            </a:extLst>
          </p:cNvPr>
          <p:cNvSpPr txBox="1"/>
          <p:nvPr/>
        </p:nvSpPr>
        <p:spPr>
          <a:xfrm rot="16200000">
            <a:off x="827706" y="2374101"/>
            <a:ext cx="156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Fold of WT mice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4331148-52AB-364C-A2BE-7CF7DB3DBAF9}"/>
              </a:ext>
            </a:extLst>
          </p:cNvPr>
          <p:cNvSpPr txBox="1"/>
          <p:nvPr/>
        </p:nvSpPr>
        <p:spPr>
          <a:xfrm rot="16200000">
            <a:off x="2980444" y="2380484"/>
            <a:ext cx="156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Fold of WT mice</a:t>
            </a:r>
            <a:endParaRPr kumimoji="1" lang="ja-JP" altLang="en-US" sz="1400" b="1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9364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574C806-5D1D-E74F-B02E-663AF20BFE54}"/>
              </a:ext>
            </a:extLst>
          </p:cNvPr>
          <p:cNvSpPr txBox="1"/>
          <p:nvPr/>
        </p:nvSpPr>
        <p:spPr>
          <a:xfrm>
            <a:off x="243040" y="229252"/>
            <a:ext cx="1339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 Figure 2</a:t>
            </a: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F4156B82-9D62-6043-9AB7-89263F9A33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4236722"/>
              </p:ext>
            </p:extLst>
          </p:nvPr>
        </p:nvGraphicFramePr>
        <p:xfrm>
          <a:off x="767892" y="1258312"/>
          <a:ext cx="4500736" cy="21897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A4634D8-EE34-5B40-929A-5492BA458A6F}"/>
              </a:ext>
            </a:extLst>
          </p:cNvPr>
          <p:cNvSpPr txBox="1"/>
          <p:nvPr/>
        </p:nvSpPr>
        <p:spPr>
          <a:xfrm rot="16200000">
            <a:off x="-35017" y="2149771"/>
            <a:ext cx="1552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  <a:cs typeface="Arial"/>
              </a:rPr>
              <a:t>Body Weight (g)</a:t>
            </a:r>
            <a:endParaRPr kumimoji="1" lang="ja-JP" altLang="en-US" sz="1400" b="1" dirty="0">
              <a:latin typeface="Helvetica" pitchFamily="2" charset="0"/>
              <a:cs typeface="Arial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501FF03-3E50-F64C-9437-08CADE2A14A8}"/>
              </a:ext>
            </a:extLst>
          </p:cNvPr>
          <p:cNvSpPr txBox="1"/>
          <p:nvPr/>
        </p:nvSpPr>
        <p:spPr>
          <a:xfrm>
            <a:off x="2122965" y="3448023"/>
            <a:ext cx="1228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ge (weeks)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E071822-CAE5-A647-9706-8D88FAFF9805}"/>
              </a:ext>
            </a:extLst>
          </p:cNvPr>
          <p:cNvSpPr txBox="1"/>
          <p:nvPr/>
        </p:nvSpPr>
        <p:spPr>
          <a:xfrm>
            <a:off x="496437" y="10247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07E2D8ED-FF6D-6E40-AFF7-30BB0364E1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3935505"/>
              </p:ext>
            </p:extLst>
          </p:nvPr>
        </p:nvGraphicFramePr>
        <p:xfrm>
          <a:off x="5654634" y="1211297"/>
          <a:ext cx="3820071" cy="22367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E0D3615-A516-514F-B637-F246981EBD22}"/>
              </a:ext>
            </a:extLst>
          </p:cNvPr>
          <p:cNvSpPr txBox="1"/>
          <p:nvPr/>
        </p:nvSpPr>
        <p:spPr>
          <a:xfrm rot="16200000">
            <a:off x="4715902" y="2152268"/>
            <a:ext cx="1678640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  <a:cs typeface="Arial"/>
              </a:rPr>
              <a:t>Plasma Pi (mg/dl)</a:t>
            </a:r>
            <a:endParaRPr lang="ja-JP" altLang="en-US" sz="1400" b="1" dirty="0">
              <a:latin typeface="Helvetica" pitchFamily="2" charset="0"/>
              <a:cs typeface="Arial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A8D9C1C-38D9-7548-813C-01A755CFC8F0}"/>
              </a:ext>
            </a:extLst>
          </p:cNvPr>
          <p:cNvSpPr txBox="1"/>
          <p:nvPr/>
        </p:nvSpPr>
        <p:spPr>
          <a:xfrm>
            <a:off x="5353912" y="10019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</a:t>
            </a:r>
            <a:endParaRPr kumimoji="1" lang="ja-JP" altLang="en-US" b="1">
              <a:latin typeface="Helvetica" pitchFamily="2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A673F3B5-7303-8D45-9C97-677842118D7A}"/>
              </a:ext>
            </a:extLst>
          </p:cNvPr>
          <p:cNvCxnSpPr/>
          <p:nvPr/>
        </p:nvCxnSpPr>
        <p:spPr>
          <a:xfrm>
            <a:off x="6454467" y="1020225"/>
            <a:ext cx="0" cy="77761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6D9BE229-A6C0-A648-8981-3FEA0B25F41F}"/>
              </a:ext>
            </a:extLst>
          </p:cNvPr>
          <p:cNvCxnSpPr>
            <a:cxnSpLocks/>
          </p:cNvCxnSpPr>
          <p:nvPr/>
        </p:nvCxnSpPr>
        <p:spPr>
          <a:xfrm>
            <a:off x="6454467" y="1020225"/>
            <a:ext cx="1362252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8F4F4FC6-42E9-FF4F-9B23-A76FD3554989}"/>
              </a:ext>
            </a:extLst>
          </p:cNvPr>
          <p:cNvCxnSpPr>
            <a:cxnSpLocks/>
          </p:cNvCxnSpPr>
          <p:nvPr/>
        </p:nvCxnSpPr>
        <p:spPr>
          <a:xfrm>
            <a:off x="7816719" y="1020225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AA302E4-50A5-CF49-AEC7-FDE617A29F4C}"/>
              </a:ext>
            </a:extLst>
          </p:cNvPr>
          <p:cNvSpPr txBox="1"/>
          <p:nvPr/>
        </p:nvSpPr>
        <p:spPr>
          <a:xfrm>
            <a:off x="6993953" y="777033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*</a:t>
            </a:r>
            <a:endParaRPr kumimoji="1" lang="ja-JP" altLang="en-US" sz="1200" b="1">
              <a:latin typeface="Helvetica" pitchFamily="2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A673F3B5-7303-8D45-9C97-677842118D7A}"/>
              </a:ext>
            </a:extLst>
          </p:cNvPr>
          <p:cNvCxnSpPr/>
          <p:nvPr/>
        </p:nvCxnSpPr>
        <p:spPr>
          <a:xfrm>
            <a:off x="6552275" y="1646946"/>
            <a:ext cx="0" cy="301779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A673F3B5-7303-8D45-9C97-677842118D7A}"/>
              </a:ext>
            </a:extLst>
          </p:cNvPr>
          <p:cNvCxnSpPr/>
          <p:nvPr/>
        </p:nvCxnSpPr>
        <p:spPr>
          <a:xfrm>
            <a:off x="6814268" y="1646946"/>
            <a:ext cx="0" cy="60960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A673F3B5-7303-8D45-9C97-677842118D7A}"/>
              </a:ext>
            </a:extLst>
          </p:cNvPr>
          <p:cNvCxnSpPr/>
          <p:nvPr/>
        </p:nvCxnSpPr>
        <p:spPr>
          <a:xfrm>
            <a:off x="7821900" y="1309521"/>
            <a:ext cx="0" cy="14366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A673F3B5-7303-8D45-9C97-677842118D7A}"/>
              </a:ext>
            </a:extLst>
          </p:cNvPr>
          <p:cNvCxnSpPr/>
          <p:nvPr/>
        </p:nvCxnSpPr>
        <p:spPr>
          <a:xfrm>
            <a:off x="8202303" y="1309521"/>
            <a:ext cx="0" cy="723995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6D9BE229-A6C0-A648-8981-3FEA0B25F41F}"/>
              </a:ext>
            </a:extLst>
          </p:cNvPr>
          <p:cNvCxnSpPr>
            <a:cxnSpLocks/>
          </p:cNvCxnSpPr>
          <p:nvPr/>
        </p:nvCxnSpPr>
        <p:spPr>
          <a:xfrm>
            <a:off x="7821900" y="1309521"/>
            <a:ext cx="380403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6D9BE229-A6C0-A648-8981-3FEA0B25F41F}"/>
              </a:ext>
            </a:extLst>
          </p:cNvPr>
          <p:cNvCxnSpPr>
            <a:cxnSpLocks/>
          </p:cNvCxnSpPr>
          <p:nvPr/>
        </p:nvCxnSpPr>
        <p:spPr>
          <a:xfrm>
            <a:off x="6552275" y="1646946"/>
            <a:ext cx="261993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AA302E4-50A5-CF49-AEC7-FDE617A29F4C}"/>
              </a:ext>
            </a:extLst>
          </p:cNvPr>
          <p:cNvSpPr txBox="1"/>
          <p:nvPr/>
        </p:nvSpPr>
        <p:spPr>
          <a:xfrm>
            <a:off x="7890112" y="99039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*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AA302E4-50A5-CF49-AEC7-FDE617A29F4C}"/>
              </a:ext>
            </a:extLst>
          </p:cNvPr>
          <p:cNvSpPr txBox="1"/>
          <p:nvPr/>
        </p:nvSpPr>
        <p:spPr>
          <a:xfrm>
            <a:off x="6570290" y="132832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*</a:t>
            </a:r>
            <a:endParaRPr kumimoji="1" lang="ja-JP" altLang="en-US" sz="1200" b="1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23901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6992547C-75A9-5642-8F83-949EA7FF0B4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7175429"/>
              </p:ext>
            </p:extLst>
          </p:nvPr>
        </p:nvGraphicFramePr>
        <p:xfrm>
          <a:off x="714151" y="783061"/>
          <a:ext cx="3820072" cy="2567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574C806-5D1D-E74F-B02E-663AF20BFE54}"/>
              </a:ext>
            </a:extLst>
          </p:cNvPr>
          <p:cNvSpPr txBox="1"/>
          <p:nvPr/>
        </p:nvSpPr>
        <p:spPr>
          <a:xfrm>
            <a:off x="243040" y="172093"/>
            <a:ext cx="1303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 figure 3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6D4F8E7-FE6D-9E4D-9D49-566D1110A86C}"/>
              </a:ext>
            </a:extLst>
          </p:cNvPr>
          <p:cNvSpPr txBox="1"/>
          <p:nvPr/>
        </p:nvSpPr>
        <p:spPr>
          <a:xfrm rot="16200000">
            <a:off x="-296098" y="1729551"/>
            <a:ext cx="1699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itchFamily="2" charset="0"/>
              </a:rPr>
              <a:t>1</a:t>
            </a:r>
            <a:r>
              <a:rPr kumimoji="1" lang="en-US" altLang="ja-JP" sz="1400" b="1" dirty="0">
                <a:latin typeface="Symbol" panose="05050102010706020507" pitchFamily="18" charset="2"/>
                <a:cs typeface="Symbol" charset="2"/>
              </a:rPr>
              <a:t>a</a:t>
            </a:r>
            <a:r>
              <a:rPr kumimoji="1" lang="en-US" altLang="ja-JP" sz="1400" b="1" dirty="0">
                <a:latin typeface="Helvetica" pitchFamily="2" charset="0"/>
              </a:rPr>
              <a:t>OHase /GAPDH</a:t>
            </a:r>
          </a:p>
        </p:txBody>
      </p:sp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7D9F1131-2E52-744D-B344-856461C6C6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1450788"/>
              </p:ext>
            </p:extLst>
          </p:nvPr>
        </p:nvGraphicFramePr>
        <p:xfrm>
          <a:off x="5284632" y="882451"/>
          <a:ext cx="3820072" cy="2567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133E703-E31C-6540-AA72-740D1E7D2ED4}"/>
              </a:ext>
            </a:extLst>
          </p:cNvPr>
          <p:cNvSpPr txBox="1"/>
          <p:nvPr/>
        </p:nvSpPr>
        <p:spPr>
          <a:xfrm rot="16200000">
            <a:off x="4374234" y="1760413"/>
            <a:ext cx="1649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itchFamily="2" charset="0"/>
              </a:rPr>
              <a:t>24OHase/GAPDH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163EEDF-2292-6944-9A21-39D3CBD00E01}"/>
              </a:ext>
            </a:extLst>
          </p:cNvPr>
          <p:cNvSpPr txBox="1"/>
          <p:nvPr/>
        </p:nvSpPr>
        <p:spPr>
          <a:xfrm>
            <a:off x="1798421" y="891888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C76A4E3-02F9-224E-A5A5-204BFDCCF507}"/>
              </a:ext>
            </a:extLst>
          </p:cNvPr>
          <p:cNvSpPr txBox="1"/>
          <p:nvPr/>
        </p:nvSpPr>
        <p:spPr>
          <a:xfrm>
            <a:off x="3864004" y="2389740"/>
            <a:ext cx="494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a’, d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0A23BF8-937C-7142-9499-3147364C72CE}"/>
              </a:ext>
            </a:extLst>
          </p:cNvPr>
          <p:cNvSpPr txBox="1"/>
          <p:nvPr/>
        </p:nvSpPr>
        <p:spPr>
          <a:xfrm>
            <a:off x="73988" y="8047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8F97194-A552-B542-A62F-67B5FEFB283F}"/>
              </a:ext>
            </a:extLst>
          </p:cNvPr>
          <p:cNvSpPr txBox="1"/>
          <p:nvPr/>
        </p:nvSpPr>
        <p:spPr>
          <a:xfrm>
            <a:off x="4487953" y="80125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5909AA4-C855-7A40-8BEA-C0A14AE59E2E}"/>
              </a:ext>
            </a:extLst>
          </p:cNvPr>
          <p:cNvSpPr txBox="1"/>
          <p:nvPr/>
        </p:nvSpPr>
        <p:spPr>
          <a:xfrm>
            <a:off x="138303" y="42451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C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750260C-4B2B-9242-A6B5-DD2C825B9CB3}"/>
              </a:ext>
            </a:extLst>
          </p:cNvPr>
          <p:cNvSpPr txBox="1"/>
          <p:nvPr/>
        </p:nvSpPr>
        <p:spPr>
          <a:xfrm>
            <a:off x="4603891" y="424555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D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60E6399-70DF-BF4B-9AE6-1BC8A82F1616}"/>
              </a:ext>
            </a:extLst>
          </p:cNvPr>
          <p:cNvSpPr txBox="1"/>
          <p:nvPr/>
        </p:nvSpPr>
        <p:spPr>
          <a:xfrm rot="16200000">
            <a:off x="4821" y="5191622"/>
            <a:ext cx="1438190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Ionized </a:t>
            </a:r>
            <a:r>
              <a:rPr lang="en-US" altLang="ja-JP" sz="1400" b="1" dirty="0" err="1">
                <a:latin typeface="Helvetica" pitchFamily="2" charset="0"/>
              </a:rPr>
              <a:t>Ca</a:t>
            </a:r>
            <a:r>
              <a:rPr lang="en-US" altLang="ja-JP" sz="1400" b="1" dirty="0">
                <a:latin typeface="Helvetica" pitchFamily="2" charset="0"/>
              </a:rPr>
              <a:t> </a:t>
            </a:r>
            <a:r>
              <a:rPr lang="en-US" altLang="ja-JP" sz="1400" b="1" dirty="0" err="1">
                <a:latin typeface="Helvetica" pitchFamily="2" charset="0"/>
              </a:rPr>
              <a:t>mM</a:t>
            </a:r>
            <a:endParaRPr lang="ja-JP" altLang="en-US" sz="1400" b="1" dirty="0">
              <a:latin typeface="Helvetica" pitchFamily="2" charset="0"/>
            </a:endParaRPr>
          </a:p>
        </p:txBody>
      </p:sp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4298EF0A-553C-B241-BFEC-5C32A634CE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0207862"/>
              </p:ext>
            </p:extLst>
          </p:nvPr>
        </p:nvGraphicFramePr>
        <p:xfrm>
          <a:off x="769002" y="4273417"/>
          <a:ext cx="3813352" cy="2567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ECC25398-ECEF-AE4C-ACEF-7E8EE18F43AE}"/>
              </a:ext>
            </a:extLst>
          </p:cNvPr>
          <p:cNvSpPr txBox="1"/>
          <p:nvPr/>
        </p:nvSpPr>
        <p:spPr>
          <a:xfrm>
            <a:off x="2394601" y="4273575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, a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B9CC285-9787-A44D-8E1F-8AAC8C97D488}"/>
              </a:ext>
            </a:extLst>
          </p:cNvPr>
          <p:cNvSpPr txBox="1"/>
          <p:nvPr/>
        </p:nvSpPr>
        <p:spPr>
          <a:xfrm>
            <a:off x="2935923" y="4291303"/>
            <a:ext cx="4413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, a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2C2B91EA-BBE2-F649-B42B-FA68B2758C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2935741"/>
              </p:ext>
            </p:extLst>
          </p:nvPr>
        </p:nvGraphicFramePr>
        <p:xfrm>
          <a:off x="5273516" y="4273418"/>
          <a:ext cx="3820072" cy="2567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4AE172A-C336-8D4B-AC26-E6416B530461}"/>
              </a:ext>
            </a:extLst>
          </p:cNvPr>
          <p:cNvSpPr txBox="1"/>
          <p:nvPr/>
        </p:nvSpPr>
        <p:spPr>
          <a:xfrm rot="16200000">
            <a:off x="4201913" y="5092427"/>
            <a:ext cx="2173969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  <a:cs typeface="Arial"/>
              </a:rPr>
              <a:t>24-hr urine Ca (mg/day)</a:t>
            </a:r>
            <a:endParaRPr lang="ja-JP" altLang="en-US" sz="1400" b="1" dirty="0">
              <a:latin typeface="Helvetica" pitchFamily="2" charset="0"/>
              <a:cs typeface="Arial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30DB52C-FCEA-4548-90E1-191AECAC2E2A}"/>
              </a:ext>
            </a:extLst>
          </p:cNvPr>
          <p:cNvSpPr txBox="1"/>
          <p:nvPr/>
        </p:nvSpPr>
        <p:spPr>
          <a:xfrm>
            <a:off x="6840337" y="4349410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’, a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2CB74FBF-1842-9E4D-AF5F-C5DB00E8CCB3}"/>
              </a:ext>
            </a:extLst>
          </p:cNvPr>
          <p:cNvSpPr txBox="1"/>
          <p:nvPr/>
        </p:nvSpPr>
        <p:spPr>
          <a:xfrm>
            <a:off x="7321627" y="5008042"/>
            <a:ext cx="7521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’, a’, b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08BA9B7-7C27-5F49-BFB2-188375428902}"/>
              </a:ext>
            </a:extLst>
          </p:cNvPr>
          <p:cNvSpPr txBox="1"/>
          <p:nvPr/>
        </p:nvSpPr>
        <p:spPr>
          <a:xfrm>
            <a:off x="8467739" y="5813915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b’, c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3EBA331-D123-AF4E-919A-58B4255C2D84}"/>
              </a:ext>
            </a:extLst>
          </p:cNvPr>
          <p:cNvSpPr txBox="1"/>
          <p:nvPr/>
        </p:nvSpPr>
        <p:spPr>
          <a:xfrm>
            <a:off x="6391824" y="573005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973CF9C3-9532-9A42-B992-EBEB4DAB1BA1}"/>
              </a:ext>
            </a:extLst>
          </p:cNvPr>
          <p:cNvSpPr txBox="1"/>
          <p:nvPr/>
        </p:nvSpPr>
        <p:spPr>
          <a:xfrm>
            <a:off x="7854833" y="5742666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, b’, c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CC25398-ECEF-AE4C-ACEF-7E8EE18F43AE}"/>
              </a:ext>
            </a:extLst>
          </p:cNvPr>
          <p:cNvSpPr txBox="1"/>
          <p:nvPr/>
        </p:nvSpPr>
        <p:spPr>
          <a:xfrm>
            <a:off x="2304787" y="1886270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, a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CC25398-ECEF-AE4C-ACEF-7E8EE18F43AE}"/>
              </a:ext>
            </a:extLst>
          </p:cNvPr>
          <p:cNvSpPr txBox="1"/>
          <p:nvPr/>
        </p:nvSpPr>
        <p:spPr>
          <a:xfrm>
            <a:off x="2844736" y="2272506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, a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CC25398-ECEF-AE4C-ACEF-7E8EE18F43AE}"/>
              </a:ext>
            </a:extLst>
          </p:cNvPr>
          <p:cNvSpPr txBox="1"/>
          <p:nvPr/>
        </p:nvSpPr>
        <p:spPr>
          <a:xfrm>
            <a:off x="3361063" y="1744939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#, a’</a:t>
            </a:r>
            <a:endParaRPr kumimoji="1" lang="ja-JP" altLang="en-US" sz="1200" b="1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71745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00000000-0008-0000-05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6121349"/>
              </p:ext>
            </p:extLst>
          </p:nvPr>
        </p:nvGraphicFramePr>
        <p:xfrm>
          <a:off x="7671260" y="823814"/>
          <a:ext cx="1556759" cy="22397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00000000-0008-0000-04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8372955"/>
              </p:ext>
            </p:extLst>
          </p:nvPr>
        </p:nvGraphicFramePr>
        <p:xfrm>
          <a:off x="5712704" y="7759831"/>
          <a:ext cx="3841182" cy="2562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9554424"/>
              </p:ext>
            </p:extLst>
          </p:nvPr>
        </p:nvGraphicFramePr>
        <p:xfrm>
          <a:off x="1027558" y="7759831"/>
          <a:ext cx="3841182" cy="2562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00000000-0008-0000-05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0243806"/>
              </p:ext>
            </p:extLst>
          </p:nvPr>
        </p:nvGraphicFramePr>
        <p:xfrm>
          <a:off x="5536056" y="823814"/>
          <a:ext cx="1556759" cy="22397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E4C489-DAE6-8149-8AF3-1DD61BF186DB}"/>
              </a:ext>
            </a:extLst>
          </p:cNvPr>
          <p:cNvSpPr txBox="1"/>
          <p:nvPr/>
        </p:nvSpPr>
        <p:spPr>
          <a:xfrm>
            <a:off x="6537086" y="1535111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Helvetica" pitchFamily="2" charset="0"/>
                <a:cs typeface="Arial"/>
              </a:rPr>
              <a:t>*</a:t>
            </a:r>
            <a:r>
              <a:rPr kumimoji="1" lang="ja-JP" altLang="en-US" sz="1100" b="1" dirty="0">
                <a:latin typeface="Helvetica" pitchFamily="2" charset="0"/>
                <a:cs typeface="Arial"/>
              </a:rPr>
              <a:t>*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C4FCBB0-2B33-364B-834F-9FCB48811B40}"/>
              </a:ext>
            </a:extLst>
          </p:cNvPr>
          <p:cNvSpPr txBox="1"/>
          <p:nvPr/>
        </p:nvSpPr>
        <p:spPr>
          <a:xfrm>
            <a:off x="5878331" y="546067"/>
            <a:ext cx="1281096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pPr algn="ctr"/>
            <a:r>
              <a:rPr lang="en-US" altLang="ja-JP" sz="1400" b="1" dirty="0">
                <a:latin typeface="Helvetica" pitchFamily="2" charset="0"/>
                <a:cs typeface="Arial"/>
              </a:rPr>
              <a:t>Npt2a</a:t>
            </a:r>
            <a:r>
              <a:rPr lang="ja-JP" altLang="en-US" sz="1400" b="1">
                <a:latin typeface="Helvetica" pitchFamily="2" charset="0"/>
                <a:cs typeface="Arial"/>
              </a:rPr>
              <a:t> </a:t>
            </a:r>
            <a:r>
              <a:rPr lang="en-US" altLang="ja-JP" sz="1400" b="1" dirty="0">
                <a:latin typeface="Helvetica" pitchFamily="2" charset="0"/>
                <a:cs typeface="Arial"/>
              </a:rPr>
              <a:t>mRNA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96C6C68-6C79-E94D-9CCB-C496BAE68A0F}"/>
              </a:ext>
            </a:extLst>
          </p:cNvPr>
          <p:cNvSpPr txBox="1"/>
          <p:nvPr/>
        </p:nvSpPr>
        <p:spPr>
          <a:xfrm>
            <a:off x="8025908" y="541577"/>
            <a:ext cx="1281096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pPr algn="ctr"/>
            <a:r>
              <a:rPr lang="en-US" altLang="ja-JP" sz="1400" b="1" dirty="0">
                <a:latin typeface="Helvetica" pitchFamily="2" charset="0"/>
                <a:cs typeface="Arial"/>
              </a:rPr>
              <a:t>Npt2c mRNA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8A9BE75-EFE7-7C47-8943-8DAD70CB06AB}"/>
              </a:ext>
            </a:extLst>
          </p:cNvPr>
          <p:cNvSpPr txBox="1"/>
          <p:nvPr/>
        </p:nvSpPr>
        <p:spPr>
          <a:xfrm>
            <a:off x="77876" y="-43724"/>
            <a:ext cx="1339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 Figure 4</a:t>
            </a:r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7EFD58C-4C97-BA43-807C-09C0547F570D}"/>
              </a:ext>
            </a:extLst>
          </p:cNvPr>
          <p:cNvSpPr txBox="1"/>
          <p:nvPr/>
        </p:nvSpPr>
        <p:spPr>
          <a:xfrm>
            <a:off x="1553418" y="7871966"/>
            <a:ext cx="159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itchFamily="2" charset="0"/>
              </a:rPr>
              <a:t>1</a:t>
            </a:r>
            <a:r>
              <a:rPr kumimoji="1" lang="en-US" altLang="ja-JP" sz="1400" b="1" dirty="0">
                <a:latin typeface="Symbol" panose="05050102010706020507" pitchFamily="18" charset="2"/>
                <a:cs typeface="Symbol" charset="2"/>
              </a:rPr>
              <a:t>a</a:t>
            </a:r>
            <a:r>
              <a:rPr kumimoji="1" lang="en-US" altLang="ja-JP" sz="1400" b="1" dirty="0">
                <a:latin typeface="Helvetica" pitchFamily="2" charset="0"/>
              </a:rPr>
              <a:t>OHase mRNA 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960EE4F-C68A-3945-8FE7-9B9933AEBF37}"/>
              </a:ext>
            </a:extLst>
          </p:cNvPr>
          <p:cNvSpPr txBox="1"/>
          <p:nvPr/>
        </p:nvSpPr>
        <p:spPr>
          <a:xfrm>
            <a:off x="6366368" y="7766536"/>
            <a:ext cx="15504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itchFamily="2" charset="0"/>
              </a:rPr>
              <a:t>24OHase mRNA</a:t>
            </a:r>
          </a:p>
        </p:txBody>
      </p:sp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AC72A197-0684-5740-9CAF-8E8217FE38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6931566"/>
              </p:ext>
            </p:extLst>
          </p:nvPr>
        </p:nvGraphicFramePr>
        <p:xfrm>
          <a:off x="938372" y="823814"/>
          <a:ext cx="1556759" cy="22397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F1D512A-AC8C-0B4E-A28C-7BF9612BA1BD}"/>
              </a:ext>
            </a:extLst>
          </p:cNvPr>
          <p:cNvSpPr txBox="1"/>
          <p:nvPr/>
        </p:nvSpPr>
        <p:spPr>
          <a:xfrm rot="16200000">
            <a:off x="75517" y="1574462"/>
            <a:ext cx="1438190" cy="307764"/>
          </a:xfrm>
          <a:prstGeom prst="rect">
            <a:avLst/>
          </a:prstGeom>
          <a:noFill/>
          <a:ln>
            <a:noFill/>
          </a:ln>
        </p:spPr>
        <p:txBody>
          <a:bodyPr wrap="none" lIns="91428" tIns="45714" rIns="91428" bIns="45714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Ionized </a:t>
            </a:r>
            <a:r>
              <a:rPr lang="en-US" altLang="ja-JP" sz="1400" b="1" dirty="0" err="1">
                <a:latin typeface="Helvetica" pitchFamily="2" charset="0"/>
              </a:rPr>
              <a:t>Ca</a:t>
            </a:r>
            <a:r>
              <a:rPr lang="en-US" altLang="ja-JP" sz="1400" b="1" dirty="0">
                <a:latin typeface="Helvetica" pitchFamily="2" charset="0"/>
              </a:rPr>
              <a:t> </a:t>
            </a:r>
            <a:r>
              <a:rPr lang="en-US" altLang="ja-JP" sz="1400" b="1" dirty="0" err="1">
                <a:latin typeface="Helvetica" pitchFamily="2" charset="0"/>
              </a:rPr>
              <a:t>mM</a:t>
            </a:r>
            <a:endParaRPr lang="ja-JP" altLang="en-US" sz="1400" b="1" dirty="0">
              <a:latin typeface="Helvetica" pitchFamily="2" charset="0"/>
            </a:endParaRPr>
          </a:p>
        </p:txBody>
      </p:sp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28B2BA55-EACA-0B43-BB78-C9F80FD1DD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3919311"/>
              </p:ext>
            </p:extLst>
          </p:nvPr>
        </p:nvGraphicFramePr>
        <p:xfrm>
          <a:off x="982482" y="4436165"/>
          <a:ext cx="3841182" cy="2562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3630B39-1F91-444E-8C64-40FDE139FC19}"/>
              </a:ext>
            </a:extLst>
          </p:cNvPr>
          <p:cNvSpPr txBox="1"/>
          <p:nvPr/>
        </p:nvSpPr>
        <p:spPr>
          <a:xfrm rot="16200000">
            <a:off x="101070" y="5359496"/>
            <a:ext cx="1438190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Ionized </a:t>
            </a:r>
            <a:r>
              <a:rPr lang="en-US" altLang="ja-JP" sz="1400" b="1" dirty="0" err="1">
                <a:latin typeface="Helvetica" pitchFamily="2" charset="0"/>
              </a:rPr>
              <a:t>Ca</a:t>
            </a:r>
            <a:r>
              <a:rPr lang="en-US" altLang="ja-JP" sz="1400" b="1" dirty="0">
                <a:latin typeface="Helvetica" pitchFamily="2" charset="0"/>
              </a:rPr>
              <a:t> </a:t>
            </a:r>
            <a:r>
              <a:rPr lang="en-US" altLang="ja-JP" sz="1400" b="1" dirty="0" err="1">
                <a:latin typeface="Helvetica" pitchFamily="2" charset="0"/>
              </a:rPr>
              <a:t>mM</a:t>
            </a:r>
            <a:endParaRPr lang="ja-JP" altLang="en-US" sz="1400" b="1" dirty="0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C343737-41B7-7A41-9C33-8021CE564089}"/>
              </a:ext>
            </a:extLst>
          </p:cNvPr>
          <p:cNvSpPr txBox="1"/>
          <p:nvPr/>
        </p:nvSpPr>
        <p:spPr>
          <a:xfrm>
            <a:off x="2489146" y="4507345"/>
            <a:ext cx="4956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#’, a’</a:t>
            </a:r>
            <a:endParaRPr kumimoji="1" lang="ja-JP" altLang="en-US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9CCAD7F-D64F-6948-AC9E-B508919E05FE}"/>
              </a:ext>
            </a:extLst>
          </p:cNvPr>
          <p:cNvSpPr txBox="1"/>
          <p:nvPr/>
        </p:nvSpPr>
        <p:spPr>
          <a:xfrm>
            <a:off x="3564742" y="4564383"/>
            <a:ext cx="57259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Helvetica" pitchFamily="2" charset="0"/>
              </a:rPr>
              <a:t>#’, a’, </a:t>
            </a:r>
          </a:p>
          <a:p>
            <a:pPr algn="ctr"/>
            <a:r>
              <a:rPr kumimoji="1" lang="en-US" altLang="ja-JP" sz="1100" b="1" dirty="0">
                <a:latin typeface="Helvetica" pitchFamily="2" charset="0"/>
              </a:rPr>
              <a:t>b’, c’</a:t>
            </a:r>
            <a:endParaRPr kumimoji="1" lang="ja-JP" altLang="en-US" sz="1400" b="1" dirty="0">
              <a:latin typeface="Helvetica" pitchFamily="2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E95348A-9691-DE41-8B1A-530FEA29ACE5}"/>
              </a:ext>
            </a:extLst>
          </p:cNvPr>
          <p:cNvSpPr txBox="1"/>
          <p:nvPr/>
        </p:nvSpPr>
        <p:spPr>
          <a:xfrm>
            <a:off x="3043970" y="4576832"/>
            <a:ext cx="4956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Helvetica" pitchFamily="2" charset="0"/>
              </a:rPr>
              <a:t>#’, a’</a:t>
            </a:r>
            <a:endParaRPr kumimoji="1" lang="ja-JP" altLang="en-US" sz="1400" b="1" dirty="0">
              <a:latin typeface="Helvetica" pitchFamily="2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C11107C-DAE5-8B46-B105-A467C389492D}"/>
              </a:ext>
            </a:extLst>
          </p:cNvPr>
          <p:cNvSpPr txBox="1"/>
          <p:nvPr/>
        </p:nvSpPr>
        <p:spPr>
          <a:xfrm>
            <a:off x="4089324" y="4804294"/>
            <a:ext cx="7056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Helvetica" pitchFamily="2" charset="0"/>
              </a:rPr>
              <a:t>b’, c’, d’</a:t>
            </a:r>
            <a:endParaRPr kumimoji="1" lang="ja-JP" altLang="en-US" sz="1400" b="1" dirty="0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AE5EAD6-DC79-AE4F-B999-421AF07C459A}"/>
              </a:ext>
            </a:extLst>
          </p:cNvPr>
          <p:cNvSpPr txBox="1"/>
          <p:nvPr/>
        </p:nvSpPr>
        <p:spPr>
          <a:xfrm>
            <a:off x="286757" y="7265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ECBAD79-2B0E-8744-B83C-FF2A401A1967}"/>
              </a:ext>
            </a:extLst>
          </p:cNvPr>
          <p:cNvSpPr txBox="1"/>
          <p:nvPr/>
        </p:nvSpPr>
        <p:spPr>
          <a:xfrm>
            <a:off x="365857" y="4410494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D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6FF27D5-9288-AF4E-A86F-259DE940D835}"/>
              </a:ext>
            </a:extLst>
          </p:cNvPr>
          <p:cNvSpPr txBox="1"/>
          <p:nvPr/>
        </p:nvSpPr>
        <p:spPr>
          <a:xfrm>
            <a:off x="425669" y="765652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F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D7D3CB1-3CE1-DE4E-A6F2-40698388E530}"/>
              </a:ext>
            </a:extLst>
          </p:cNvPr>
          <p:cNvSpPr txBox="1"/>
          <p:nvPr/>
        </p:nvSpPr>
        <p:spPr>
          <a:xfrm>
            <a:off x="5022005" y="7656523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>
                <a:latin typeface="Helvetica" pitchFamily="2" charset="0"/>
              </a:rPr>
              <a:t>G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00E8C6E-D88E-9747-9B4F-3D9C93414617}"/>
              </a:ext>
            </a:extLst>
          </p:cNvPr>
          <p:cNvSpPr txBox="1"/>
          <p:nvPr/>
        </p:nvSpPr>
        <p:spPr>
          <a:xfrm rot="16200000">
            <a:off x="114400" y="8640787"/>
            <a:ext cx="156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Fold of WT mice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032E802-BE0B-6344-84E7-C32086D11A6B}"/>
              </a:ext>
            </a:extLst>
          </p:cNvPr>
          <p:cNvSpPr txBox="1"/>
          <p:nvPr/>
        </p:nvSpPr>
        <p:spPr>
          <a:xfrm rot="16200000">
            <a:off x="4824102" y="8590841"/>
            <a:ext cx="156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Fold of WT mice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BB4D5E8-A483-7543-9013-10BCA0F31A4D}"/>
              </a:ext>
            </a:extLst>
          </p:cNvPr>
          <p:cNvSpPr txBox="1"/>
          <p:nvPr/>
        </p:nvSpPr>
        <p:spPr>
          <a:xfrm rot="16200000">
            <a:off x="4615164" y="1642832"/>
            <a:ext cx="156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Fold of WT mice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631AD65-D0E7-9E49-A9B8-A3194FA8FF39}"/>
              </a:ext>
            </a:extLst>
          </p:cNvPr>
          <p:cNvSpPr txBox="1"/>
          <p:nvPr/>
        </p:nvSpPr>
        <p:spPr>
          <a:xfrm rot="16200000">
            <a:off x="6713250" y="1612103"/>
            <a:ext cx="156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Fold of WT mice</a:t>
            </a:r>
            <a:endParaRPr kumimoji="1" lang="ja-JP" altLang="en-US" sz="1400" b="1">
              <a:latin typeface="Helvetica" pitchFamily="2" charset="0"/>
            </a:endParaRPr>
          </a:p>
        </p:txBody>
      </p:sp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84A25630-BB89-8743-A863-AAD3D154E8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5520825"/>
              </p:ext>
            </p:extLst>
          </p:nvPr>
        </p:nvGraphicFramePr>
        <p:xfrm>
          <a:off x="3033163" y="806575"/>
          <a:ext cx="1643519" cy="22570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ED0E48CF-6505-E340-99A0-830438BE3C4E}"/>
              </a:ext>
            </a:extLst>
          </p:cNvPr>
          <p:cNvSpPr txBox="1"/>
          <p:nvPr/>
        </p:nvSpPr>
        <p:spPr>
          <a:xfrm>
            <a:off x="4920502" y="7066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C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5FC59E5-BE72-014D-8551-99614A21F7EF}"/>
              </a:ext>
            </a:extLst>
          </p:cNvPr>
          <p:cNvSpPr txBox="1"/>
          <p:nvPr/>
        </p:nvSpPr>
        <p:spPr>
          <a:xfrm rot="16200000">
            <a:off x="1801581" y="1527182"/>
            <a:ext cx="2173969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  <a:cs typeface="Arial"/>
              </a:rPr>
              <a:t>24 </a:t>
            </a:r>
            <a:r>
              <a:rPr lang="en-US" altLang="ja-JP" sz="1400" b="1" dirty="0" err="1">
                <a:latin typeface="Helvetica" pitchFamily="2" charset="0"/>
                <a:cs typeface="Arial"/>
              </a:rPr>
              <a:t>hr</a:t>
            </a:r>
            <a:r>
              <a:rPr lang="en-US" altLang="ja-JP" sz="1400" b="1" dirty="0">
                <a:latin typeface="Helvetica" pitchFamily="2" charset="0"/>
                <a:cs typeface="Arial"/>
              </a:rPr>
              <a:t> urine </a:t>
            </a:r>
            <a:r>
              <a:rPr lang="en-US" altLang="ja-JP" sz="1400" b="1" dirty="0" err="1">
                <a:latin typeface="Helvetica" pitchFamily="2" charset="0"/>
                <a:cs typeface="Arial"/>
              </a:rPr>
              <a:t>Ca</a:t>
            </a:r>
            <a:r>
              <a:rPr lang="en-US" altLang="ja-JP" sz="1400" b="1" dirty="0">
                <a:latin typeface="Helvetica" pitchFamily="2" charset="0"/>
                <a:cs typeface="Arial"/>
              </a:rPr>
              <a:t> (mg/day)</a:t>
            </a:r>
            <a:endParaRPr lang="ja-JP" altLang="en-US" sz="1400" b="1" dirty="0">
              <a:latin typeface="Helvetica" pitchFamily="2" charset="0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123085" y="802033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</a:p>
        </p:txBody>
      </p:sp>
      <p:graphicFrame>
        <p:nvGraphicFramePr>
          <p:cNvPr id="38" name="グラフ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8956891"/>
              </p:ext>
            </p:extLst>
          </p:nvPr>
        </p:nvGraphicFramePr>
        <p:xfrm>
          <a:off x="5670771" y="4420817"/>
          <a:ext cx="3841200" cy="256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3630B39-1F91-444E-8C64-40FDE139FC19}"/>
              </a:ext>
            </a:extLst>
          </p:cNvPr>
          <p:cNvSpPr txBox="1"/>
          <p:nvPr/>
        </p:nvSpPr>
        <p:spPr>
          <a:xfrm rot="16200000">
            <a:off x="4424019" y="5216497"/>
            <a:ext cx="2173969" cy="307764"/>
          </a:xfrm>
          <a:prstGeom prst="rect">
            <a:avLst/>
          </a:prstGeom>
          <a:noFill/>
        </p:spPr>
        <p:txBody>
          <a:bodyPr wrap="none" lIns="91428" tIns="45714" rIns="91428" bIns="45714" rtlCol="0">
            <a:spAutoFit/>
          </a:bodyPr>
          <a:lstStyle/>
          <a:p>
            <a:r>
              <a:rPr lang="en-US" altLang="ja-JP" sz="1400" b="1">
                <a:latin typeface="Helvetica" pitchFamily="2" charset="0"/>
              </a:rPr>
              <a:t>24-hr </a:t>
            </a:r>
            <a:r>
              <a:rPr lang="en-US" altLang="ja-JP" sz="1400" b="1" dirty="0">
                <a:latin typeface="Helvetica" pitchFamily="2" charset="0"/>
              </a:rPr>
              <a:t>urine Ca (mg/day)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199976" y="4347791"/>
            <a:ext cx="4956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#’, a’</a:t>
            </a:r>
            <a:endParaRPr kumimoji="1" lang="ja-JP" altLang="en-US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7847462" y="5343083"/>
            <a:ext cx="3097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b’</a:t>
            </a:r>
            <a:endParaRPr kumimoji="1" lang="ja-JP" altLang="en-US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338783" y="5349925"/>
            <a:ext cx="4651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#, b’</a:t>
            </a:r>
            <a:endParaRPr kumimoji="1" lang="ja-JP" altLang="en-US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8950541" y="5660452"/>
            <a:ext cx="3097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b’</a:t>
            </a:r>
            <a:endParaRPr kumimoji="1" lang="ja-JP" altLang="en-US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E59BA68-32DA-D54D-90E1-1DBBFFF06B4E}"/>
              </a:ext>
            </a:extLst>
          </p:cNvPr>
          <p:cNvSpPr txBox="1"/>
          <p:nvPr/>
        </p:nvSpPr>
        <p:spPr>
          <a:xfrm>
            <a:off x="4946873" y="43874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E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72E77AC1-C461-D544-8A90-DEB591F2C2F0}"/>
              </a:ext>
            </a:extLst>
          </p:cNvPr>
          <p:cNvSpPr txBox="1"/>
          <p:nvPr/>
        </p:nvSpPr>
        <p:spPr>
          <a:xfrm>
            <a:off x="6719073" y="5691867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AE89FAF-F745-BE48-AC2F-9AD19605DCEC}"/>
              </a:ext>
            </a:extLst>
          </p:cNvPr>
          <p:cNvSpPr txBox="1"/>
          <p:nvPr/>
        </p:nvSpPr>
        <p:spPr>
          <a:xfrm>
            <a:off x="6719073" y="5724710"/>
            <a:ext cx="301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>
                <a:latin typeface="Helvetica" panose="020B0604020202020204" pitchFamily="34" charset="0"/>
                <a:cs typeface="Helvetica" panose="020B0604020202020204" pitchFamily="34" charset="0"/>
              </a:rPr>
              <a:t>#’</a:t>
            </a:r>
            <a:endParaRPr kumimoji="1" lang="ja-JP" altLang="en-US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DD532B82-08BC-0545-B290-79B423E9CF50}"/>
              </a:ext>
            </a:extLst>
          </p:cNvPr>
          <p:cNvSpPr txBox="1"/>
          <p:nvPr/>
        </p:nvSpPr>
        <p:spPr>
          <a:xfrm>
            <a:off x="2432688" y="7066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</a:t>
            </a:r>
            <a:endParaRPr kumimoji="1" lang="ja-JP" altLang="en-US" b="1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15997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グラフ 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0667899"/>
              </p:ext>
            </p:extLst>
          </p:nvPr>
        </p:nvGraphicFramePr>
        <p:xfrm>
          <a:off x="3753903" y="7132975"/>
          <a:ext cx="2516400" cy="225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21C6D96-9671-BF4B-A1EB-438CEA6556C2}"/>
              </a:ext>
            </a:extLst>
          </p:cNvPr>
          <p:cNvSpPr txBox="1"/>
          <p:nvPr/>
        </p:nvSpPr>
        <p:spPr>
          <a:xfrm rot="16200000">
            <a:off x="3430140" y="1390354"/>
            <a:ext cx="1178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Npt2a/Actin</a:t>
            </a:r>
            <a:endParaRPr kumimoji="1" lang="ja-JP" altLang="en-US" sz="1400" b="1" dirty="0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5C03386-AEE3-D94A-8760-AE9873B8E2AF}"/>
              </a:ext>
            </a:extLst>
          </p:cNvPr>
          <p:cNvSpPr txBox="1"/>
          <p:nvPr/>
        </p:nvSpPr>
        <p:spPr>
          <a:xfrm rot="16200000">
            <a:off x="6243106" y="1381542"/>
            <a:ext cx="1178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Npt2c/Actin</a:t>
            </a:r>
            <a:endParaRPr kumimoji="1" lang="ja-JP" altLang="en-US" sz="1400" b="1" dirty="0">
              <a:latin typeface="Helvetica" pitchFamily="2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5873A02D-88C5-C243-B5BD-A144975B68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6387" y="3520800"/>
            <a:ext cx="2880000" cy="288000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DCA547AC-7EBE-AB41-B74D-89FB7BE351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000" y="3520800"/>
            <a:ext cx="2880000" cy="288000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011D2C2-1157-B747-963D-090042038F72}"/>
              </a:ext>
            </a:extLst>
          </p:cNvPr>
          <p:cNvSpPr txBox="1"/>
          <p:nvPr/>
        </p:nvSpPr>
        <p:spPr>
          <a:xfrm>
            <a:off x="2954186" y="3520800"/>
            <a:ext cx="5610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srgbClr val="FFFFFF"/>
                </a:solidFill>
                <a:latin typeface="Helvetica" pitchFamily="2" charset="0"/>
                <a:cs typeface="Arial"/>
              </a:rPr>
              <a:t>21D</a:t>
            </a:r>
            <a:endParaRPr kumimoji="1" lang="ja-JP" altLang="en-US" sz="1600" b="1" dirty="0">
              <a:solidFill>
                <a:srgbClr val="FFFFFF"/>
              </a:solidFill>
              <a:latin typeface="Helvetica" pitchFamily="2" charset="0"/>
              <a:cs typeface="Arial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BD8C45E-AD50-784B-B956-DDEF8760B9F8}"/>
              </a:ext>
            </a:extLst>
          </p:cNvPr>
          <p:cNvSpPr txBox="1"/>
          <p:nvPr/>
        </p:nvSpPr>
        <p:spPr>
          <a:xfrm>
            <a:off x="2815612" y="3777477"/>
            <a:ext cx="75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solidFill>
                  <a:srgbClr val="FFFFFF"/>
                </a:solidFill>
                <a:latin typeface="Helvetica" pitchFamily="2" charset="0"/>
                <a:cs typeface="Arial"/>
              </a:rPr>
              <a:t>Npt2c</a:t>
            </a:r>
            <a:endParaRPr kumimoji="1" lang="ja-JP" altLang="en-US" sz="1600" b="1" dirty="0">
              <a:solidFill>
                <a:srgbClr val="FFFFFF"/>
              </a:solidFill>
              <a:latin typeface="Helvetica" pitchFamily="2" charset="0"/>
              <a:cs typeface="Arial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6A6131C4-EF85-BA4E-832D-F25BE5A1365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6658" y="3520800"/>
            <a:ext cx="2880000" cy="2880000"/>
          </a:xfrm>
          <a:prstGeom prst="rect">
            <a:avLst/>
          </a:prstGeom>
        </p:spPr>
      </p:pic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47B2BAE-7649-F84C-86AF-0D574BB7CC9E}"/>
              </a:ext>
            </a:extLst>
          </p:cNvPr>
          <p:cNvSpPr txBox="1"/>
          <p:nvPr/>
        </p:nvSpPr>
        <p:spPr>
          <a:xfrm>
            <a:off x="5893226" y="3520800"/>
            <a:ext cx="5610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srgbClr val="FFFFFF"/>
                </a:solidFill>
                <a:latin typeface="Helvetica" pitchFamily="2" charset="0"/>
                <a:cs typeface="Arial"/>
              </a:rPr>
              <a:t>28D</a:t>
            </a:r>
            <a:endParaRPr kumimoji="1" lang="ja-JP" altLang="en-US" sz="1600" b="1" dirty="0">
              <a:solidFill>
                <a:srgbClr val="FFFFFF"/>
              </a:solidFill>
              <a:latin typeface="Helvetica" pitchFamily="2" charset="0"/>
              <a:cs typeface="Arial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D52AD8A-E0DA-9D42-8D9D-5A33B4D51227}"/>
              </a:ext>
            </a:extLst>
          </p:cNvPr>
          <p:cNvSpPr txBox="1"/>
          <p:nvPr/>
        </p:nvSpPr>
        <p:spPr>
          <a:xfrm>
            <a:off x="5738059" y="3790036"/>
            <a:ext cx="75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solidFill>
                  <a:srgbClr val="FFFFFF"/>
                </a:solidFill>
                <a:latin typeface="Helvetica" pitchFamily="2" charset="0"/>
                <a:cs typeface="Arial"/>
              </a:rPr>
              <a:t>Npt2c</a:t>
            </a:r>
            <a:endParaRPr kumimoji="1" lang="ja-JP" altLang="en-US" sz="1600" b="1" dirty="0">
              <a:solidFill>
                <a:srgbClr val="FFFFFF"/>
              </a:solidFill>
              <a:latin typeface="Helvetica" pitchFamily="2" charset="0"/>
              <a:cs typeface="Arial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35BA0EB-A2EF-C441-887B-A01017F30B47}"/>
              </a:ext>
            </a:extLst>
          </p:cNvPr>
          <p:cNvSpPr txBox="1"/>
          <p:nvPr/>
        </p:nvSpPr>
        <p:spPr>
          <a:xfrm>
            <a:off x="8746539" y="3520800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chemeClr val="bg1"/>
                </a:solidFill>
                <a:latin typeface="Helvetica" pitchFamily="2" charset="0"/>
              </a:rPr>
              <a:t>60D</a:t>
            </a:r>
            <a:endParaRPr kumimoji="1" lang="ja-JP" altLang="en-US" b="1" dirty="0">
              <a:solidFill>
                <a:schemeClr val="bg1"/>
              </a:solidFill>
              <a:latin typeface="Helvetica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6AE0627-F63D-184B-8E85-9E358937294B}"/>
              </a:ext>
            </a:extLst>
          </p:cNvPr>
          <p:cNvSpPr txBox="1"/>
          <p:nvPr/>
        </p:nvSpPr>
        <p:spPr>
          <a:xfrm>
            <a:off x="8638072" y="3845947"/>
            <a:ext cx="75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solidFill>
                  <a:srgbClr val="FFFFFF"/>
                </a:solidFill>
                <a:latin typeface="Helvetica" pitchFamily="2" charset="0"/>
                <a:cs typeface="Arial"/>
              </a:rPr>
              <a:t>Npt2c</a:t>
            </a:r>
            <a:endParaRPr kumimoji="1" lang="ja-JP" altLang="en-US" sz="1600" b="1" dirty="0">
              <a:solidFill>
                <a:srgbClr val="FFFFFF"/>
              </a:solidFill>
              <a:latin typeface="Helvetica" pitchFamily="2" charset="0"/>
              <a:cs typeface="Arial"/>
            </a:endParaRPr>
          </a:p>
        </p:txBody>
      </p:sp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D6A13CE1-32F6-0447-8EAD-DE97057E50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8588289"/>
              </p:ext>
            </p:extLst>
          </p:nvPr>
        </p:nvGraphicFramePr>
        <p:xfrm>
          <a:off x="698235" y="7153398"/>
          <a:ext cx="2552703" cy="2256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4BDF226-C279-654B-9889-F027B7FF9650}"/>
              </a:ext>
            </a:extLst>
          </p:cNvPr>
          <p:cNvSpPr txBox="1"/>
          <p:nvPr/>
        </p:nvSpPr>
        <p:spPr>
          <a:xfrm rot="16200000">
            <a:off x="-355110" y="7997538"/>
            <a:ext cx="18678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Plasma PTH (</a:t>
            </a:r>
            <a:r>
              <a:rPr kumimoji="1" lang="en-US" altLang="ja-JP" sz="1400" b="1" dirty="0" err="1">
                <a:latin typeface="Helvetica" pitchFamily="2" charset="0"/>
              </a:rPr>
              <a:t>pg</a:t>
            </a:r>
            <a:r>
              <a:rPr kumimoji="1" lang="en-US" altLang="ja-JP" sz="1400" b="1" dirty="0">
                <a:latin typeface="Helvetica" pitchFamily="2" charset="0"/>
              </a:rPr>
              <a:t>/ml)</a:t>
            </a:r>
            <a:endParaRPr kumimoji="1" lang="ja-JP" altLang="en-US" sz="1400" b="1" dirty="0">
              <a:latin typeface="Helvetica" pitchFamily="2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6911F77-9316-5B43-B898-2C27BDDC6D83}"/>
              </a:ext>
            </a:extLst>
          </p:cNvPr>
          <p:cNvSpPr txBox="1"/>
          <p:nvPr/>
        </p:nvSpPr>
        <p:spPr>
          <a:xfrm rot="16200000">
            <a:off x="2650843" y="7997539"/>
            <a:ext cx="1996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Serum FGF23 (</a:t>
            </a:r>
            <a:r>
              <a:rPr kumimoji="1" lang="en-US" altLang="ja-JP" sz="1400" b="1" dirty="0" err="1">
                <a:latin typeface="Helvetica" pitchFamily="2" charset="0"/>
              </a:rPr>
              <a:t>pg</a:t>
            </a:r>
            <a:r>
              <a:rPr kumimoji="1" lang="en-US" altLang="ja-JP" sz="1400" b="1" dirty="0">
                <a:latin typeface="Helvetica" pitchFamily="2" charset="0"/>
              </a:rPr>
              <a:t>/ml)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80B44AD-2F71-484C-B3C6-59E9D43F26C6}"/>
              </a:ext>
            </a:extLst>
          </p:cNvPr>
          <p:cNvSpPr txBox="1"/>
          <p:nvPr/>
        </p:nvSpPr>
        <p:spPr>
          <a:xfrm>
            <a:off x="166493" y="6145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ure 5</a:t>
            </a:r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3D62484-B3A6-D945-AFDF-8F770885E206}"/>
              </a:ext>
            </a:extLst>
          </p:cNvPr>
          <p:cNvSpPr txBox="1"/>
          <p:nvPr/>
        </p:nvSpPr>
        <p:spPr>
          <a:xfrm>
            <a:off x="5131022" y="843470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, b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9E4F303-BCF4-9042-A5DE-FDC6F412FC36}"/>
              </a:ext>
            </a:extLst>
          </p:cNvPr>
          <p:cNvSpPr txBox="1"/>
          <p:nvPr/>
        </p:nvSpPr>
        <p:spPr>
          <a:xfrm>
            <a:off x="4725886" y="815326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28135FC-BB0C-7E48-B9F3-8AE1D09533DA}"/>
              </a:ext>
            </a:extLst>
          </p:cNvPr>
          <p:cNvSpPr txBox="1"/>
          <p:nvPr/>
        </p:nvSpPr>
        <p:spPr>
          <a:xfrm>
            <a:off x="5623465" y="790259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b, c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1F8FFB6-2545-D74D-8769-85A9064545A9}"/>
              </a:ext>
            </a:extLst>
          </p:cNvPr>
          <p:cNvSpPr txBox="1"/>
          <p:nvPr/>
        </p:nvSpPr>
        <p:spPr>
          <a:xfrm>
            <a:off x="1707761" y="8183729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’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B85687D-27A5-564F-B36D-F22DDF803775}"/>
              </a:ext>
            </a:extLst>
          </p:cNvPr>
          <p:cNvSpPr txBox="1"/>
          <p:nvPr/>
        </p:nvSpPr>
        <p:spPr>
          <a:xfrm>
            <a:off x="2713297" y="810219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graphicFrame>
        <p:nvGraphicFramePr>
          <p:cNvPr id="46" name="グラフ 45">
            <a:extLst>
              <a:ext uri="{FF2B5EF4-FFF2-40B4-BE49-F238E27FC236}">
                <a16:creationId xmlns:a16="http://schemas.microsoft.com/office/drawing/2014/main" id="{B640396F-C756-C441-B2B5-5945503793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7833318"/>
              </p:ext>
            </p:extLst>
          </p:nvPr>
        </p:nvGraphicFramePr>
        <p:xfrm>
          <a:off x="7022747" y="503808"/>
          <a:ext cx="2552703" cy="2256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6" name="図 5">
            <a:extLst>
              <a:ext uri="{FF2B5EF4-FFF2-40B4-BE49-F238E27FC236}">
                <a16:creationId xmlns:a16="http://schemas.microsoft.com/office/drawing/2014/main" id="{9B0F5625-4C4B-1947-8224-A15B384A297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180" y="979354"/>
            <a:ext cx="3581400" cy="1511300"/>
          </a:xfrm>
          <a:prstGeom prst="rect">
            <a:avLst/>
          </a:prstGeom>
        </p:spPr>
      </p:pic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F73BC1D-21F6-C048-AE1B-DDD1A22D3D77}"/>
              </a:ext>
            </a:extLst>
          </p:cNvPr>
          <p:cNvSpPr txBox="1"/>
          <p:nvPr/>
        </p:nvSpPr>
        <p:spPr>
          <a:xfrm>
            <a:off x="2218531" y="8158397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’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D3F6FC9-D996-4948-8177-BCEE4FCA0A25}"/>
              </a:ext>
            </a:extLst>
          </p:cNvPr>
          <p:cNvSpPr txBox="1"/>
          <p:nvPr/>
        </p:nvSpPr>
        <p:spPr>
          <a:xfrm>
            <a:off x="320381" y="52507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9ACA8EEA-9646-654E-A5D2-9D47159597FD}"/>
              </a:ext>
            </a:extLst>
          </p:cNvPr>
          <p:cNvSpPr txBox="1"/>
          <p:nvPr/>
        </p:nvSpPr>
        <p:spPr>
          <a:xfrm>
            <a:off x="268421" y="31727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CE50761-40C7-7640-AB9D-E07E2490E34E}"/>
              </a:ext>
            </a:extLst>
          </p:cNvPr>
          <p:cNvSpPr txBox="1"/>
          <p:nvPr/>
        </p:nvSpPr>
        <p:spPr>
          <a:xfrm>
            <a:off x="238801" y="675133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C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2BFD617E-1B99-6640-9BAC-13A09C0F9185}"/>
              </a:ext>
            </a:extLst>
          </p:cNvPr>
          <p:cNvSpPr txBox="1"/>
          <p:nvPr/>
        </p:nvSpPr>
        <p:spPr>
          <a:xfrm>
            <a:off x="3294142" y="675133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D</a:t>
            </a:r>
            <a:endParaRPr kumimoji="1" lang="ja-JP" altLang="en-US" b="1">
              <a:latin typeface="Helvetica" pitchFamily="2" charset="0"/>
            </a:endParaRPr>
          </a:p>
        </p:txBody>
      </p:sp>
      <p:graphicFrame>
        <p:nvGraphicFramePr>
          <p:cNvPr id="53" name="グラフ 52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9245992"/>
              </p:ext>
            </p:extLst>
          </p:nvPr>
        </p:nvGraphicFramePr>
        <p:xfrm>
          <a:off x="4199089" y="503808"/>
          <a:ext cx="2552702" cy="2256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0459B5E-2374-444A-B153-3F0D01E57D97}"/>
              </a:ext>
            </a:extLst>
          </p:cNvPr>
          <p:cNvSpPr txBox="1"/>
          <p:nvPr/>
        </p:nvSpPr>
        <p:spPr>
          <a:xfrm>
            <a:off x="5557055" y="832850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’,</a:t>
            </a:r>
            <a:r>
              <a:rPr kumimoji="1" lang="ja-JP" altLang="en-US" sz="1400" b="1" dirty="0">
                <a:latin typeface="Helvetica" pitchFamily="2" charset="0"/>
              </a:rPr>
              <a:t> </a:t>
            </a:r>
            <a:r>
              <a:rPr kumimoji="1" lang="en-US" altLang="ja-JP" sz="1400" b="1" dirty="0">
                <a:latin typeface="Helvetica" pitchFamily="2" charset="0"/>
              </a:rPr>
              <a:t>b’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9AE931A0-ABE4-6643-A310-77E4568D4606}"/>
              </a:ext>
            </a:extLst>
          </p:cNvPr>
          <p:cNvSpPr txBox="1"/>
          <p:nvPr/>
        </p:nvSpPr>
        <p:spPr>
          <a:xfrm>
            <a:off x="6090332" y="503697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’,</a:t>
            </a:r>
            <a:r>
              <a:rPr kumimoji="1" lang="ja-JP" altLang="en-US" sz="1400" b="1">
                <a:latin typeface="Helvetica" pitchFamily="2" charset="0"/>
              </a:rPr>
              <a:t> </a:t>
            </a:r>
            <a:r>
              <a:rPr kumimoji="1" lang="en-US" altLang="ja-JP" sz="1400" b="1" dirty="0">
                <a:latin typeface="Helvetica" pitchFamily="2" charset="0"/>
              </a:rPr>
              <a:t>b’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813CC5B-F9B9-A146-B55A-62CE0209DD65}"/>
              </a:ext>
            </a:extLst>
          </p:cNvPr>
          <p:cNvSpPr txBox="1"/>
          <p:nvPr/>
        </p:nvSpPr>
        <p:spPr>
          <a:xfrm>
            <a:off x="8363149" y="380442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’,</a:t>
            </a:r>
            <a:r>
              <a:rPr kumimoji="1" lang="ja-JP" altLang="en-US" sz="1400" b="1">
                <a:latin typeface="Helvetica" pitchFamily="2" charset="0"/>
              </a:rPr>
              <a:t> </a:t>
            </a:r>
            <a:r>
              <a:rPr kumimoji="1" lang="en-US" altLang="ja-JP" sz="1400" b="1" dirty="0">
                <a:latin typeface="Helvetica" pitchFamily="2" charset="0"/>
              </a:rPr>
              <a:t>b’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4EAE22E-A44D-B54F-8939-2CD9F949A3C6}"/>
              </a:ext>
            </a:extLst>
          </p:cNvPr>
          <p:cNvSpPr txBox="1"/>
          <p:nvPr/>
        </p:nvSpPr>
        <p:spPr>
          <a:xfrm>
            <a:off x="8952521" y="50863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,</a:t>
            </a:r>
            <a:r>
              <a:rPr kumimoji="1" lang="ja-JP" altLang="en-US" sz="1400" b="1">
                <a:latin typeface="Helvetica" pitchFamily="2" charset="0"/>
              </a:rPr>
              <a:t> </a:t>
            </a:r>
            <a:r>
              <a:rPr kumimoji="1" lang="en-US" altLang="ja-JP" sz="1400" b="1" dirty="0">
                <a:latin typeface="Helvetica" pitchFamily="2" charset="0"/>
              </a:rPr>
              <a:t>b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8" name="フリーフォーム 7">
            <a:extLst>
              <a:ext uri="{FF2B5EF4-FFF2-40B4-BE49-F238E27FC236}">
                <a16:creationId xmlns:a16="http://schemas.microsoft.com/office/drawing/2014/main" id="{6F833ED4-B377-314E-8D57-1AEFF2B0ED1D}"/>
              </a:ext>
            </a:extLst>
          </p:cNvPr>
          <p:cNvSpPr/>
          <p:nvPr/>
        </p:nvSpPr>
        <p:spPr>
          <a:xfrm>
            <a:off x="628650" y="3600035"/>
            <a:ext cx="1228725" cy="943390"/>
          </a:xfrm>
          <a:custGeom>
            <a:avLst/>
            <a:gdLst>
              <a:gd name="connsiteX0" fmla="*/ 0 w 1228725"/>
              <a:gd name="connsiteY0" fmla="*/ 943390 h 943390"/>
              <a:gd name="connsiteX1" fmla="*/ 28575 w 1228725"/>
              <a:gd name="connsiteY1" fmla="*/ 843378 h 943390"/>
              <a:gd name="connsiteX2" fmla="*/ 71438 w 1228725"/>
              <a:gd name="connsiteY2" fmla="*/ 757653 h 943390"/>
              <a:gd name="connsiteX3" fmla="*/ 114300 w 1228725"/>
              <a:gd name="connsiteY3" fmla="*/ 729078 h 943390"/>
              <a:gd name="connsiteX4" fmla="*/ 185738 w 1228725"/>
              <a:gd name="connsiteY4" fmla="*/ 657640 h 943390"/>
              <a:gd name="connsiteX5" fmla="*/ 214313 w 1228725"/>
              <a:gd name="connsiteY5" fmla="*/ 614778 h 943390"/>
              <a:gd name="connsiteX6" fmla="*/ 257175 w 1228725"/>
              <a:gd name="connsiteY6" fmla="*/ 571915 h 943390"/>
              <a:gd name="connsiteX7" fmla="*/ 285750 w 1228725"/>
              <a:gd name="connsiteY7" fmla="*/ 529053 h 943390"/>
              <a:gd name="connsiteX8" fmla="*/ 371475 w 1228725"/>
              <a:gd name="connsiteY8" fmla="*/ 486190 h 943390"/>
              <a:gd name="connsiteX9" fmla="*/ 457200 w 1228725"/>
              <a:gd name="connsiteY9" fmla="*/ 443328 h 943390"/>
              <a:gd name="connsiteX10" fmla="*/ 585788 w 1228725"/>
              <a:gd name="connsiteY10" fmla="*/ 357603 h 943390"/>
              <a:gd name="connsiteX11" fmla="*/ 628650 w 1228725"/>
              <a:gd name="connsiteY11" fmla="*/ 329028 h 943390"/>
              <a:gd name="connsiteX12" fmla="*/ 671513 w 1228725"/>
              <a:gd name="connsiteY12" fmla="*/ 300453 h 943390"/>
              <a:gd name="connsiteX13" fmla="*/ 771525 w 1228725"/>
              <a:gd name="connsiteY13" fmla="*/ 200440 h 943390"/>
              <a:gd name="connsiteX14" fmla="*/ 857250 w 1228725"/>
              <a:gd name="connsiteY14" fmla="*/ 143290 h 943390"/>
              <a:gd name="connsiteX15" fmla="*/ 900113 w 1228725"/>
              <a:gd name="connsiteY15" fmla="*/ 114715 h 943390"/>
              <a:gd name="connsiteX16" fmla="*/ 942975 w 1228725"/>
              <a:gd name="connsiteY16" fmla="*/ 100428 h 943390"/>
              <a:gd name="connsiteX17" fmla="*/ 985838 w 1228725"/>
              <a:gd name="connsiteY17" fmla="*/ 71853 h 943390"/>
              <a:gd name="connsiteX18" fmla="*/ 1071563 w 1228725"/>
              <a:gd name="connsiteY18" fmla="*/ 43278 h 943390"/>
              <a:gd name="connsiteX19" fmla="*/ 1114425 w 1228725"/>
              <a:gd name="connsiteY19" fmla="*/ 28990 h 943390"/>
              <a:gd name="connsiteX20" fmla="*/ 1214438 w 1228725"/>
              <a:gd name="connsiteY20" fmla="*/ 415 h 943390"/>
              <a:gd name="connsiteX21" fmla="*/ 1228725 w 1228725"/>
              <a:gd name="connsiteY21" fmla="*/ 415 h 9433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1228725" h="943390">
                <a:moveTo>
                  <a:pt x="0" y="943390"/>
                </a:moveTo>
                <a:cubicBezTo>
                  <a:pt x="9525" y="910053"/>
                  <a:pt x="18612" y="876587"/>
                  <a:pt x="28575" y="843378"/>
                </a:cubicBezTo>
                <a:cubicBezTo>
                  <a:pt x="38535" y="810177"/>
                  <a:pt x="45634" y="783457"/>
                  <a:pt x="71438" y="757653"/>
                </a:cubicBezTo>
                <a:cubicBezTo>
                  <a:pt x="83580" y="745511"/>
                  <a:pt x="100013" y="738603"/>
                  <a:pt x="114300" y="729078"/>
                </a:cubicBezTo>
                <a:cubicBezTo>
                  <a:pt x="190497" y="614781"/>
                  <a:pt x="90490" y="752887"/>
                  <a:pt x="185738" y="657640"/>
                </a:cubicBezTo>
                <a:cubicBezTo>
                  <a:pt x="197880" y="645498"/>
                  <a:pt x="203320" y="627969"/>
                  <a:pt x="214313" y="614778"/>
                </a:cubicBezTo>
                <a:cubicBezTo>
                  <a:pt x="227248" y="599256"/>
                  <a:pt x="244240" y="587437"/>
                  <a:pt x="257175" y="571915"/>
                </a:cubicBezTo>
                <a:cubicBezTo>
                  <a:pt x="268168" y="558724"/>
                  <a:pt x="273608" y="541195"/>
                  <a:pt x="285750" y="529053"/>
                </a:cubicBezTo>
                <a:cubicBezTo>
                  <a:pt x="326695" y="488108"/>
                  <a:pt x="324995" y="509430"/>
                  <a:pt x="371475" y="486190"/>
                </a:cubicBezTo>
                <a:cubicBezTo>
                  <a:pt x="482254" y="430800"/>
                  <a:pt x="349473" y="479236"/>
                  <a:pt x="457200" y="443328"/>
                </a:cubicBezTo>
                <a:lnTo>
                  <a:pt x="585788" y="357603"/>
                </a:lnTo>
                <a:lnTo>
                  <a:pt x="628650" y="329028"/>
                </a:lnTo>
                <a:lnTo>
                  <a:pt x="671513" y="300453"/>
                </a:lnTo>
                <a:cubicBezTo>
                  <a:pt x="696660" y="225009"/>
                  <a:pt x="673269" y="265944"/>
                  <a:pt x="771525" y="200440"/>
                </a:cubicBezTo>
                <a:lnTo>
                  <a:pt x="857250" y="143290"/>
                </a:lnTo>
                <a:cubicBezTo>
                  <a:pt x="871538" y="133765"/>
                  <a:pt x="883823" y="120145"/>
                  <a:pt x="900113" y="114715"/>
                </a:cubicBezTo>
                <a:lnTo>
                  <a:pt x="942975" y="100428"/>
                </a:lnTo>
                <a:cubicBezTo>
                  <a:pt x="957263" y="90903"/>
                  <a:pt x="970146" y="78827"/>
                  <a:pt x="985838" y="71853"/>
                </a:cubicBezTo>
                <a:cubicBezTo>
                  <a:pt x="1013363" y="59620"/>
                  <a:pt x="1042988" y="52803"/>
                  <a:pt x="1071563" y="43278"/>
                </a:cubicBezTo>
                <a:lnTo>
                  <a:pt x="1114425" y="28990"/>
                </a:lnTo>
                <a:cubicBezTo>
                  <a:pt x="1155269" y="15375"/>
                  <a:pt x="1169599" y="9383"/>
                  <a:pt x="1214438" y="415"/>
                </a:cubicBezTo>
                <a:cubicBezTo>
                  <a:pt x="1219108" y="-519"/>
                  <a:pt x="1223963" y="415"/>
                  <a:pt x="1228725" y="415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フリーフォーム 8">
            <a:extLst>
              <a:ext uri="{FF2B5EF4-FFF2-40B4-BE49-F238E27FC236}">
                <a16:creationId xmlns:a16="http://schemas.microsoft.com/office/drawing/2014/main" id="{9A1D76C4-8F94-9A43-84C3-846F8C3D5C91}"/>
              </a:ext>
            </a:extLst>
          </p:cNvPr>
          <p:cNvSpPr/>
          <p:nvPr/>
        </p:nvSpPr>
        <p:spPr>
          <a:xfrm>
            <a:off x="3571875" y="3557588"/>
            <a:ext cx="1071563" cy="800100"/>
          </a:xfrm>
          <a:custGeom>
            <a:avLst/>
            <a:gdLst>
              <a:gd name="connsiteX0" fmla="*/ 0 w 1071563"/>
              <a:gd name="connsiteY0" fmla="*/ 800100 h 800100"/>
              <a:gd name="connsiteX1" fmla="*/ 100013 w 1071563"/>
              <a:gd name="connsiteY1" fmla="*/ 642937 h 800100"/>
              <a:gd name="connsiteX2" fmla="*/ 142875 w 1071563"/>
              <a:gd name="connsiteY2" fmla="*/ 600075 h 800100"/>
              <a:gd name="connsiteX3" fmla="*/ 200025 w 1071563"/>
              <a:gd name="connsiteY3" fmla="*/ 514350 h 800100"/>
              <a:gd name="connsiteX4" fmla="*/ 242888 w 1071563"/>
              <a:gd name="connsiteY4" fmla="*/ 485775 h 800100"/>
              <a:gd name="connsiteX5" fmla="*/ 285750 w 1071563"/>
              <a:gd name="connsiteY5" fmla="*/ 442912 h 800100"/>
              <a:gd name="connsiteX6" fmla="*/ 328613 w 1071563"/>
              <a:gd name="connsiteY6" fmla="*/ 428625 h 800100"/>
              <a:gd name="connsiteX7" fmla="*/ 371475 w 1071563"/>
              <a:gd name="connsiteY7" fmla="*/ 400050 h 800100"/>
              <a:gd name="connsiteX8" fmla="*/ 457200 w 1071563"/>
              <a:gd name="connsiteY8" fmla="*/ 371475 h 800100"/>
              <a:gd name="connsiteX9" fmla="*/ 500063 w 1071563"/>
              <a:gd name="connsiteY9" fmla="*/ 342900 h 800100"/>
              <a:gd name="connsiteX10" fmla="*/ 542925 w 1071563"/>
              <a:gd name="connsiteY10" fmla="*/ 328612 h 800100"/>
              <a:gd name="connsiteX11" fmla="*/ 628650 w 1071563"/>
              <a:gd name="connsiteY11" fmla="*/ 271462 h 800100"/>
              <a:gd name="connsiteX12" fmla="*/ 671513 w 1071563"/>
              <a:gd name="connsiteY12" fmla="*/ 242887 h 800100"/>
              <a:gd name="connsiteX13" fmla="*/ 700088 w 1071563"/>
              <a:gd name="connsiteY13" fmla="*/ 200025 h 800100"/>
              <a:gd name="connsiteX14" fmla="*/ 828675 w 1071563"/>
              <a:gd name="connsiteY14" fmla="*/ 100012 h 800100"/>
              <a:gd name="connsiteX15" fmla="*/ 871538 w 1071563"/>
              <a:gd name="connsiteY15" fmla="*/ 71437 h 800100"/>
              <a:gd name="connsiteX16" fmla="*/ 914400 w 1071563"/>
              <a:gd name="connsiteY16" fmla="*/ 42862 h 800100"/>
              <a:gd name="connsiteX17" fmla="*/ 957263 w 1071563"/>
              <a:gd name="connsiteY17" fmla="*/ 28575 h 800100"/>
              <a:gd name="connsiteX18" fmla="*/ 1071563 w 1071563"/>
              <a:gd name="connsiteY18" fmla="*/ 0 h 800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071563" h="800100">
                <a:moveTo>
                  <a:pt x="0" y="800100"/>
                </a:moveTo>
                <a:cubicBezTo>
                  <a:pt x="33338" y="747712"/>
                  <a:pt x="56105" y="686845"/>
                  <a:pt x="100013" y="642937"/>
                </a:cubicBezTo>
                <a:cubicBezTo>
                  <a:pt x="114300" y="628650"/>
                  <a:pt x="130470" y="616024"/>
                  <a:pt x="142875" y="600075"/>
                </a:cubicBezTo>
                <a:cubicBezTo>
                  <a:pt x="163959" y="572966"/>
                  <a:pt x="171450" y="533400"/>
                  <a:pt x="200025" y="514350"/>
                </a:cubicBezTo>
                <a:cubicBezTo>
                  <a:pt x="214313" y="504825"/>
                  <a:pt x="229696" y="496768"/>
                  <a:pt x="242888" y="485775"/>
                </a:cubicBezTo>
                <a:cubicBezTo>
                  <a:pt x="258410" y="472840"/>
                  <a:pt x="268938" y="454120"/>
                  <a:pt x="285750" y="442912"/>
                </a:cubicBezTo>
                <a:cubicBezTo>
                  <a:pt x="298281" y="434558"/>
                  <a:pt x="314325" y="433387"/>
                  <a:pt x="328613" y="428625"/>
                </a:cubicBezTo>
                <a:cubicBezTo>
                  <a:pt x="342900" y="419100"/>
                  <a:pt x="355784" y="407024"/>
                  <a:pt x="371475" y="400050"/>
                </a:cubicBezTo>
                <a:cubicBezTo>
                  <a:pt x="399000" y="387817"/>
                  <a:pt x="457200" y="371475"/>
                  <a:pt x="457200" y="371475"/>
                </a:cubicBezTo>
                <a:cubicBezTo>
                  <a:pt x="471488" y="361950"/>
                  <a:pt x="484704" y="350579"/>
                  <a:pt x="500063" y="342900"/>
                </a:cubicBezTo>
                <a:cubicBezTo>
                  <a:pt x="513533" y="336165"/>
                  <a:pt x="529760" y="335926"/>
                  <a:pt x="542925" y="328612"/>
                </a:cubicBezTo>
                <a:cubicBezTo>
                  <a:pt x="572946" y="311933"/>
                  <a:pt x="600075" y="290512"/>
                  <a:pt x="628650" y="271462"/>
                </a:cubicBezTo>
                <a:lnTo>
                  <a:pt x="671513" y="242887"/>
                </a:lnTo>
                <a:cubicBezTo>
                  <a:pt x="681038" y="228600"/>
                  <a:pt x="689095" y="213216"/>
                  <a:pt x="700088" y="200025"/>
                </a:cubicBezTo>
                <a:cubicBezTo>
                  <a:pt x="742056" y="149663"/>
                  <a:pt x="768932" y="139841"/>
                  <a:pt x="828675" y="100012"/>
                </a:cubicBezTo>
                <a:lnTo>
                  <a:pt x="871538" y="71437"/>
                </a:lnTo>
                <a:cubicBezTo>
                  <a:pt x="885825" y="61912"/>
                  <a:pt x="898110" y="48292"/>
                  <a:pt x="914400" y="42862"/>
                </a:cubicBezTo>
                <a:cubicBezTo>
                  <a:pt x="928688" y="38100"/>
                  <a:pt x="942733" y="32538"/>
                  <a:pt x="957263" y="28575"/>
                </a:cubicBezTo>
                <a:cubicBezTo>
                  <a:pt x="995152" y="18242"/>
                  <a:pt x="1071563" y="0"/>
                  <a:pt x="1071563" y="0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フリーフォーム 9">
            <a:extLst>
              <a:ext uri="{FF2B5EF4-FFF2-40B4-BE49-F238E27FC236}">
                <a16:creationId xmlns:a16="http://schemas.microsoft.com/office/drawing/2014/main" id="{8FD6EECD-C0E1-3544-8B21-0A0769ECE28B}"/>
              </a:ext>
            </a:extLst>
          </p:cNvPr>
          <p:cNvSpPr/>
          <p:nvPr/>
        </p:nvSpPr>
        <p:spPr>
          <a:xfrm>
            <a:off x="6501600" y="3556800"/>
            <a:ext cx="741600" cy="273600"/>
          </a:xfrm>
          <a:custGeom>
            <a:avLst/>
            <a:gdLst>
              <a:gd name="connsiteX0" fmla="*/ 0 w 741600"/>
              <a:gd name="connsiteY0" fmla="*/ 273600 h 273600"/>
              <a:gd name="connsiteX1" fmla="*/ 64800 w 741600"/>
              <a:gd name="connsiteY1" fmla="*/ 230400 h 273600"/>
              <a:gd name="connsiteX2" fmla="*/ 93600 w 741600"/>
              <a:gd name="connsiteY2" fmla="*/ 208800 h 273600"/>
              <a:gd name="connsiteX3" fmla="*/ 115200 w 741600"/>
              <a:gd name="connsiteY3" fmla="*/ 201600 h 273600"/>
              <a:gd name="connsiteX4" fmla="*/ 158400 w 741600"/>
              <a:gd name="connsiteY4" fmla="*/ 180000 h 273600"/>
              <a:gd name="connsiteX5" fmla="*/ 172800 w 741600"/>
              <a:gd name="connsiteY5" fmla="*/ 158400 h 273600"/>
              <a:gd name="connsiteX6" fmla="*/ 237600 w 741600"/>
              <a:gd name="connsiteY6" fmla="*/ 129600 h 273600"/>
              <a:gd name="connsiteX7" fmla="*/ 259200 w 741600"/>
              <a:gd name="connsiteY7" fmla="*/ 122400 h 273600"/>
              <a:gd name="connsiteX8" fmla="*/ 367200 w 741600"/>
              <a:gd name="connsiteY8" fmla="*/ 86400 h 273600"/>
              <a:gd name="connsiteX9" fmla="*/ 410400 w 741600"/>
              <a:gd name="connsiteY9" fmla="*/ 72000 h 273600"/>
              <a:gd name="connsiteX10" fmla="*/ 432000 w 741600"/>
              <a:gd name="connsiteY10" fmla="*/ 64800 h 273600"/>
              <a:gd name="connsiteX11" fmla="*/ 482400 w 741600"/>
              <a:gd name="connsiteY11" fmla="*/ 50400 h 273600"/>
              <a:gd name="connsiteX12" fmla="*/ 496800 w 741600"/>
              <a:gd name="connsiteY12" fmla="*/ 28800 h 273600"/>
              <a:gd name="connsiteX13" fmla="*/ 540000 w 741600"/>
              <a:gd name="connsiteY13" fmla="*/ 14400 h 273600"/>
              <a:gd name="connsiteX14" fmla="*/ 597600 w 741600"/>
              <a:gd name="connsiteY14" fmla="*/ 0 h 273600"/>
              <a:gd name="connsiteX15" fmla="*/ 741600 w 741600"/>
              <a:gd name="connsiteY15" fmla="*/ 7200 h 273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741600" h="273600">
                <a:moveTo>
                  <a:pt x="0" y="273600"/>
                </a:moveTo>
                <a:cubicBezTo>
                  <a:pt x="21600" y="259200"/>
                  <a:pt x="43456" y="245177"/>
                  <a:pt x="64800" y="230400"/>
                </a:cubicBezTo>
                <a:cubicBezTo>
                  <a:pt x="74666" y="223569"/>
                  <a:pt x="83181" y="214754"/>
                  <a:pt x="93600" y="208800"/>
                </a:cubicBezTo>
                <a:cubicBezTo>
                  <a:pt x="100190" y="205035"/>
                  <a:pt x="108412" y="204994"/>
                  <a:pt x="115200" y="201600"/>
                </a:cubicBezTo>
                <a:cubicBezTo>
                  <a:pt x="171030" y="173685"/>
                  <a:pt x="104108" y="198097"/>
                  <a:pt x="158400" y="180000"/>
                </a:cubicBezTo>
                <a:cubicBezTo>
                  <a:pt x="163200" y="172800"/>
                  <a:pt x="166681" y="164519"/>
                  <a:pt x="172800" y="158400"/>
                </a:cubicBezTo>
                <a:cubicBezTo>
                  <a:pt x="189915" y="141285"/>
                  <a:pt x="216212" y="136729"/>
                  <a:pt x="237600" y="129600"/>
                </a:cubicBezTo>
                <a:lnTo>
                  <a:pt x="259200" y="122400"/>
                </a:lnTo>
                <a:lnTo>
                  <a:pt x="367200" y="86400"/>
                </a:lnTo>
                <a:lnTo>
                  <a:pt x="410400" y="72000"/>
                </a:lnTo>
                <a:cubicBezTo>
                  <a:pt x="417600" y="69600"/>
                  <a:pt x="424637" y="66641"/>
                  <a:pt x="432000" y="64800"/>
                </a:cubicBezTo>
                <a:cubicBezTo>
                  <a:pt x="468163" y="55759"/>
                  <a:pt x="451412" y="60729"/>
                  <a:pt x="482400" y="50400"/>
                </a:cubicBezTo>
                <a:cubicBezTo>
                  <a:pt x="487200" y="43200"/>
                  <a:pt x="489462" y="33386"/>
                  <a:pt x="496800" y="28800"/>
                </a:cubicBezTo>
                <a:cubicBezTo>
                  <a:pt x="509672" y="20755"/>
                  <a:pt x="525600" y="19200"/>
                  <a:pt x="540000" y="14400"/>
                </a:cubicBezTo>
                <a:cubicBezTo>
                  <a:pt x="573210" y="3330"/>
                  <a:pt x="554158" y="8688"/>
                  <a:pt x="597600" y="0"/>
                </a:cubicBezTo>
                <a:lnTo>
                  <a:pt x="741600" y="7200"/>
                </a:ln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337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547</TotalTime>
  <Words>250</Words>
  <Application>Microsoft Macintosh PowerPoint</Application>
  <PresentationFormat>A3 297x420 mm</PresentationFormat>
  <Paragraphs>92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Helvetica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瀬川　博子</dc:creator>
  <cp:lastModifiedBy>瀬川　博子</cp:lastModifiedBy>
  <cp:revision>376</cp:revision>
  <cp:lastPrinted>2019-08-07T15:12:53Z</cp:lastPrinted>
  <dcterms:created xsi:type="dcterms:W3CDTF">2019-05-30T09:26:51Z</dcterms:created>
  <dcterms:modified xsi:type="dcterms:W3CDTF">2019-11-12T21:18:18Z</dcterms:modified>
</cp:coreProperties>
</file>